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sldIdLst>
    <p:sldId id="318" r:id="rId6"/>
    <p:sldId id="273" r:id="rId7"/>
    <p:sldId id="301" r:id="rId8"/>
    <p:sldId id="277" r:id="rId9"/>
    <p:sldId id="275" r:id="rId10"/>
    <p:sldId id="317" r:id="rId11"/>
    <p:sldId id="308" r:id="rId12"/>
    <p:sldId id="309" r:id="rId13"/>
    <p:sldId id="257" r:id="rId14"/>
    <p:sldId id="321" r:id="rId15"/>
    <p:sldId id="319" r:id="rId16"/>
    <p:sldId id="320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1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arin McKeen" userId="515e8975-6326-45d1-95a9-e54fdf3a7c64" providerId="ADAL" clId="{FAED19E0-F028-4F19-B360-B1830CB8293A}"/>
    <pc:docChg chg="modSld">
      <pc:chgData name="Starin McKeen" userId="515e8975-6326-45d1-95a9-e54fdf3a7c64" providerId="ADAL" clId="{FAED19E0-F028-4F19-B360-B1830CB8293A}" dt="2021-03-19T01:27:06.748" v="5" actId="1076"/>
      <pc:docMkLst>
        <pc:docMk/>
      </pc:docMkLst>
      <pc:sldChg chg="modSp mod">
        <pc:chgData name="Starin McKeen" userId="515e8975-6326-45d1-95a9-e54fdf3a7c64" providerId="ADAL" clId="{FAED19E0-F028-4F19-B360-B1830CB8293A}" dt="2021-03-19T01:27:06.748" v="5" actId="1076"/>
        <pc:sldMkLst>
          <pc:docMk/>
          <pc:sldMk cId="2511944828" sldId="277"/>
        </pc:sldMkLst>
        <pc:spChg chg="mod">
          <ac:chgData name="Starin McKeen" userId="515e8975-6326-45d1-95a9-e54fdf3a7c64" providerId="ADAL" clId="{FAED19E0-F028-4F19-B360-B1830CB8293A}" dt="2021-03-19T01:26:57.848" v="2" actId="1076"/>
          <ac:spMkLst>
            <pc:docMk/>
            <pc:sldMk cId="2511944828" sldId="277"/>
            <ac:spMk id="15" creationId="{0CEAAFED-D011-4289-9BFD-94426D86A923}"/>
          </ac:spMkLst>
        </pc:spChg>
        <pc:spChg chg="mod">
          <ac:chgData name="Starin McKeen" userId="515e8975-6326-45d1-95a9-e54fdf3a7c64" providerId="ADAL" clId="{FAED19E0-F028-4F19-B360-B1830CB8293A}" dt="2021-03-19T01:27:03.853" v="4" actId="1076"/>
          <ac:spMkLst>
            <pc:docMk/>
            <pc:sldMk cId="2511944828" sldId="277"/>
            <ac:spMk id="16" creationId="{0482392B-7FF7-415C-A372-3213164AA3C2}"/>
          </ac:spMkLst>
        </pc:spChg>
        <pc:spChg chg="mod">
          <ac:chgData name="Starin McKeen" userId="515e8975-6326-45d1-95a9-e54fdf3a7c64" providerId="ADAL" clId="{FAED19E0-F028-4F19-B360-B1830CB8293A}" dt="2021-03-19T01:26:59.958" v="3" actId="1076"/>
          <ac:spMkLst>
            <pc:docMk/>
            <pc:sldMk cId="2511944828" sldId="277"/>
            <ac:spMk id="17" creationId="{7D417B47-3970-4207-A862-78873217F9F8}"/>
          </ac:spMkLst>
        </pc:spChg>
        <pc:spChg chg="mod">
          <ac:chgData name="Starin McKeen" userId="515e8975-6326-45d1-95a9-e54fdf3a7c64" providerId="ADAL" clId="{FAED19E0-F028-4F19-B360-B1830CB8293A}" dt="2021-03-19T01:27:06.748" v="5" actId="1076"/>
          <ac:spMkLst>
            <pc:docMk/>
            <pc:sldMk cId="2511944828" sldId="277"/>
            <ac:spMk id="18" creationId="{1A1249BB-E366-4B96-B880-CACA4CD5BF0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5CF79-6399-4821-B08E-E3AF5B6BD9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9F68BC-C8FC-41C7-9552-E37A70988D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2468C-9F35-499D-AF37-07C4A190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F6A4E-10FD-4B80-953D-FD2E2ED6E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4D17B6-DBB9-4BE5-BCAC-EB5925415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4618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C94DC-0890-4E36-A0E1-F07EFFEB76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7930BD-6CAC-40C0-AE8D-A322E0727F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350B09-C9C5-48F1-B743-93107C4AD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F74F8-64D2-47B0-8149-DB604906E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15C54E-394C-4554-B098-2C2AAE82B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31758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8F0C27-6A8F-4376-9C58-C271E55366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2D40B5-4152-4D7C-A10B-C802090806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057B8-CC4C-4E98-BBA2-FCA870642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EDDA37-CA64-40C7-87B7-7B2C446C3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B30EA-B1E4-4170-9E31-C792D0A2A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952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41461-9519-4794-8DF7-CE2EB3BB9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9B9579-7AC5-4A55-9A61-C0D1C2C27D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94B2A-3CDF-4AD1-81BC-5A68B15F9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CF9265-C056-43E7-BFEA-551B32950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EFE4A5-DEF6-4D70-B93C-C90D617DC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46536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FA535-1564-4379-BE3F-38CB848AE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B88221-CA9B-470D-A000-8EC668225C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B089D-FF88-4DB6-B695-4EBE32D37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3E18D-4739-4FC2-9CDB-270F641B8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46221-E6D6-4E8C-857D-F60570643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40203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6F11D-7E54-4DCC-9D4C-3BFE9395B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C4A7C9-EA70-4F74-983D-60D24A251E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D8FA3-2472-4CCB-9E0E-72BF01858E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D2743E-BFE7-409F-9733-9C155F4D4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49D904-36B9-45A2-AA5E-ADF9A5322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556EBB-45AC-4884-9064-ECEF31411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9309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48ADC-C014-4ACD-9132-C32E5ABDF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ECE4B6-2EBA-4AE7-8D1A-3835C2593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3CE8A7-567D-4F93-A394-A393D41073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3B49F8-56DF-41E7-B9E6-A74BDC839A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CE7EC6-A6A1-4172-9197-C41F6A2C03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3981A1A-8671-410A-9DE3-82C933636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55ACFC-564E-454D-AA4B-3F842E725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CDE545-0E21-4E7E-A8AF-A444F0B79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64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6C180-029C-422A-B15C-D9F401A34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6ED655B-594F-4BB4-83C6-3B3105186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AF5A0F-A102-4E60-9347-B6365FBBD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0B2E5D-FCAB-4BDD-A8FA-4ADF0657B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02510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CC9D94-877D-42C5-93F4-8C9EA6771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CF6D1A-C45A-4E6B-88FF-ABC1EB774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B3C5A6-378D-4A0B-A852-C596C12E2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29539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2C78A-5ED2-408C-B848-3FD3ED943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307F41-9B89-4A6F-8DEC-5F049B5FD0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C2949A-F83D-429B-BA54-74DF7D8976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AFC861-75D5-412B-B0FB-73B5A2CFB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11F532-E85C-42F5-883B-60BE88A94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A30915-CE23-4B7F-B897-CD3B24457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36152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4140D-751B-4DA8-A128-F3B68BFC4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F05F1F-B732-4C2B-AEEF-41BD729DAB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3C8A86-B07E-4301-A0E7-07B507E6C5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6DE8D7-8EA7-4A9E-929E-BC858AE91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159CC1-66EF-4E5E-BBBF-B722B4FB5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213282-D2A4-458B-9090-C81D6141B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48710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00460A-0CB7-4C0D-92A8-BE5934CE0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D8868-5A78-41B8-80B2-DF0666A99F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5B9897-8077-4039-B9E5-380D7FD0B1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56B6A-4C00-4A14-919C-F0B25CF693FC}" type="datetimeFigureOut">
              <a:rPr lang="en-NZ" smtClean="0"/>
              <a:t>19/03/2021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BDCC9F-C984-46D4-A0F3-7AF37B3DAB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1A059-1D3B-4828-B6C3-3D04F1B2B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71D0E-52A9-4A89-A4EB-39FA1B466A5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29347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4">
            <a:extLst>
              <a:ext uri="{FF2B5EF4-FFF2-40B4-BE49-F238E27FC236}">
                <a16:creationId xmlns:a16="http://schemas.microsoft.com/office/drawing/2014/main" id="{043043DF-AD4A-4D67-A1E6-61ACE654F083}"/>
              </a:ext>
            </a:extLst>
          </p:cNvPr>
          <p:cNvGrpSpPr/>
          <p:nvPr/>
        </p:nvGrpSpPr>
        <p:grpSpPr>
          <a:xfrm>
            <a:off x="1998741" y="608671"/>
            <a:ext cx="8194518" cy="5253688"/>
            <a:chOff x="1998741" y="139544"/>
            <a:chExt cx="8194518" cy="5253688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DFFCF6B-BB1B-4D93-A7B5-CECE92CCB5DB}"/>
                </a:ext>
              </a:extLst>
            </p:cNvPr>
            <p:cNvSpPr txBox="1"/>
            <p:nvPr/>
          </p:nvSpPr>
          <p:spPr>
            <a:xfrm>
              <a:off x="4941074" y="139544"/>
              <a:ext cx="2212796" cy="276999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ssessed for eligibility (n=40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86448DE-84A5-453E-A3CB-0879643E9D79}"/>
                </a:ext>
              </a:extLst>
            </p:cNvPr>
            <p:cNvSpPr txBox="1"/>
            <p:nvPr/>
          </p:nvSpPr>
          <p:spPr>
            <a:xfrm>
              <a:off x="1998741" y="2178976"/>
              <a:ext cx="2994713" cy="461665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Prebiotic Intervention (Kumara)</a:t>
              </a:r>
            </a:p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(n=30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A659463-C16C-44F3-BDCC-F9788FEA3A48}"/>
                </a:ext>
              </a:extLst>
            </p:cNvPr>
            <p:cNvSpPr txBox="1"/>
            <p:nvPr/>
          </p:nvSpPr>
          <p:spPr>
            <a:xfrm>
              <a:off x="7198548" y="2166030"/>
              <a:ext cx="2994711" cy="461665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Probiotic Intervention</a:t>
              </a:r>
            </a:p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(n=10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DAC2DD7-1D7F-474C-AD9E-F3D8CE939F4C}"/>
                </a:ext>
              </a:extLst>
            </p:cNvPr>
            <p:cNvSpPr txBox="1"/>
            <p:nvPr/>
          </p:nvSpPr>
          <p:spPr>
            <a:xfrm>
              <a:off x="2093795" y="139544"/>
              <a:ext cx="2044700" cy="27699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Enrolmen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42640C4-EC66-4E33-8F86-FC040E00C2A7}"/>
                </a:ext>
              </a:extLst>
            </p:cNvPr>
            <p:cNvSpPr txBox="1"/>
            <p:nvPr/>
          </p:nvSpPr>
          <p:spPr>
            <a:xfrm>
              <a:off x="5073650" y="1880705"/>
              <a:ext cx="2044700" cy="27699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llocatio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F7A8AFE-95E6-45B4-A01B-088BFE36D545}"/>
                </a:ext>
              </a:extLst>
            </p:cNvPr>
            <p:cNvSpPr txBox="1"/>
            <p:nvPr/>
          </p:nvSpPr>
          <p:spPr>
            <a:xfrm>
              <a:off x="1998741" y="3179971"/>
              <a:ext cx="2994714" cy="461665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Discontinued Intervention </a:t>
              </a:r>
            </a:p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(n=3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4CFCC38-06AA-4784-ACDE-0A1EADC7A1BD}"/>
                </a:ext>
              </a:extLst>
            </p:cNvPr>
            <p:cNvSpPr txBox="1"/>
            <p:nvPr/>
          </p:nvSpPr>
          <p:spPr>
            <a:xfrm>
              <a:off x="7198546" y="3179972"/>
              <a:ext cx="2994711" cy="461665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Discontinued Intervention </a:t>
              </a:r>
            </a:p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(n=3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B264D9D-C816-43FC-AC65-55324FB9C3C5}"/>
                </a:ext>
              </a:extLst>
            </p:cNvPr>
            <p:cNvSpPr txBox="1"/>
            <p:nvPr/>
          </p:nvSpPr>
          <p:spPr>
            <a:xfrm>
              <a:off x="5073650" y="2902973"/>
              <a:ext cx="2044700" cy="27699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Follow-Up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F376DB8-59E4-4939-B4C8-8FFBF5468AD3}"/>
                </a:ext>
              </a:extLst>
            </p:cNvPr>
            <p:cNvSpPr txBox="1"/>
            <p:nvPr/>
          </p:nvSpPr>
          <p:spPr>
            <a:xfrm>
              <a:off x="1998741" y="4192903"/>
              <a:ext cx="2994714" cy="1200329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ed (n=20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Excluded from analysis (n=10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Withdrew (n=3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Incomplete sample set (n=5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Incomplete diet records (n=1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biotic prescription (n=1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623AD5A-86C4-4842-8865-915C358ED106}"/>
                </a:ext>
              </a:extLst>
            </p:cNvPr>
            <p:cNvSpPr txBox="1"/>
            <p:nvPr/>
          </p:nvSpPr>
          <p:spPr>
            <a:xfrm>
              <a:off x="7198545" y="4191585"/>
              <a:ext cx="2994712" cy="1015663"/>
            </a:xfrm>
            <a:prstGeom prst="rect">
              <a:avLst/>
            </a:prstGeom>
            <a:noFill/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ed (n=5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Excluded from analysis (n=5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Withdrew (n=3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Incomplete diet records (n =1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biotic prescription (n = 1)</a:t>
              </a:r>
            </a:p>
          </p:txBody>
        </p:sp>
        <p:sp>
          <p:nvSpPr>
            <p:cNvPr id="16" name="Right Brace 15">
              <a:extLst>
                <a:ext uri="{FF2B5EF4-FFF2-40B4-BE49-F238E27FC236}">
                  <a16:creationId xmlns:a16="http://schemas.microsoft.com/office/drawing/2014/main" id="{5C43F03E-B795-4C31-BD4F-A3131D163DEA}"/>
                </a:ext>
              </a:extLst>
            </p:cNvPr>
            <p:cNvSpPr/>
            <p:nvPr/>
          </p:nvSpPr>
          <p:spPr>
            <a:xfrm rot="16200000">
              <a:off x="5589839" y="-911713"/>
              <a:ext cx="948341" cy="5135823"/>
            </a:xfrm>
            <a:prstGeom prst="rightBrace">
              <a:avLst>
                <a:gd name="adj1" fmla="val 21513"/>
                <a:gd name="adj2" fmla="val 50046"/>
              </a:avLst>
            </a:prstGeom>
            <a:ln w="3175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Isosceles Triangle 17">
              <a:extLst>
                <a:ext uri="{FF2B5EF4-FFF2-40B4-BE49-F238E27FC236}">
                  <a16:creationId xmlns:a16="http://schemas.microsoft.com/office/drawing/2014/main" id="{281F89B4-1DE1-452C-991C-47C8C4A536EE}"/>
                </a:ext>
              </a:extLst>
            </p:cNvPr>
            <p:cNvSpPr/>
            <p:nvPr/>
          </p:nvSpPr>
          <p:spPr>
            <a:xfrm rot="10800000">
              <a:off x="8602865" y="2107510"/>
              <a:ext cx="58109" cy="45719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Isosceles Triangle 18">
              <a:extLst>
                <a:ext uri="{FF2B5EF4-FFF2-40B4-BE49-F238E27FC236}">
                  <a16:creationId xmlns:a16="http://schemas.microsoft.com/office/drawing/2014/main" id="{99B2009B-F096-4268-A569-49AE8D4E60DB}"/>
                </a:ext>
              </a:extLst>
            </p:cNvPr>
            <p:cNvSpPr/>
            <p:nvPr/>
          </p:nvSpPr>
          <p:spPr>
            <a:xfrm rot="10800000">
              <a:off x="3467044" y="2120311"/>
              <a:ext cx="58109" cy="45719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242E1E0-266A-48B8-871C-547DFC3E42D2}"/>
                </a:ext>
              </a:extLst>
            </p:cNvPr>
            <p:cNvSpPr txBox="1"/>
            <p:nvPr/>
          </p:nvSpPr>
          <p:spPr>
            <a:xfrm>
              <a:off x="5073650" y="3914586"/>
              <a:ext cx="2044700" cy="27699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1626932-3A0D-4C34-A475-27E0A6ADA9D3}"/>
                </a:ext>
              </a:extLst>
            </p:cNvPr>
            <p:cNvSpPr txBox="1"/>
            <p:nvPr/>
          </p:nvSpPr>
          <p:spPr>
            <a:xfrm>
              <a:off x="4941074" y="872325"/>
              <a:ext cx="2212796" cy="27699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Randomised (n=40)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07A889E7-4698-43FB-8863-2ABE009C440F}"/>
                </a:ext>
              </a:extLst>
            </p:cNvPr>
            <p:cNvCxnSpPr>
              <a:cxnSpLocks/>
              <a:stCxn id="3" idx="2"/>
              <a:endCxn id="17" idx="0"/>
            </p:cNvCxnSpPr>
            <p:nvPr/>
          </p:nvCxnSpPr>
          <p:spPr>
            <a:xfrm>
              <a:off x="6047472" y="416543"/>
              <a:ext cx="0" cy="45578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0776CD8A-B01B-4348-8558-97B47D733ECF}"/>
                </a:ext>
              </a:extLst>
            </p:cNvPr>
            <p:cNvCxnSpPr>
              <a:cxnSpLocks/>
              <a:stCxn id="6" idx="2"/>
              <a:endCxn id="12" idx="0"/>
            </p:cNvCxnSpPr>
            <p:nvPr/>
          </p:nvCxnSpPr>
          <p:spPr>
            <a:xfrm flipH="1">
              <a:off x="8695902" y="2627695"/>
              <a:ext cx="2" cy="552277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B0DC7EE3-4160-432C-984D-E02AF66EFE61}"/>
                </a:ext>
              </a:extLst>
            </p:cNvPr>
            <p:cNvCxnSpPr>
              <a:cxnSpLocks/>
              <a:stCxn id="12" idx="2"/>
              <a:endCxn id="15" idx="0"/>
            </p:cNvCxnSpPr>
            <p:nvPr/>
          </p:nvCxnSpPr>
          <p:spPr>
            <a:xfrm flipH="1">
              <a:off x="8695901" y="3641637"/>
              <a:ext cx="1" cy="54994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3B15620F-01C3-41DB-84D6-8C7FEC761B0E}"/>
                </a:ext>
              </a:extLst>
            </p:cNvPr>
            <p:cNvCxnSpPr>
              <a:cxnSpLocks/>
              <a:stCxn id="5" idx="2"/>
              <a:endCxn id="11" idx="0"/>
            </p:cNvCxnSpPr>
            <p:nvPr/>
          </p:nvCxnSpPr>
          <p:spPr>
            <a:xfrm>
              <a:off x="3496098" y="2640641"/>
              <a:ext cx="0" cy="53933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0211E7B-8EF7-4BB0-9874-8F87407266E7}"/>
                </a:ext>
              </a:extLst>
            </p:cNvPr>
            <p:cNvCxnSpPr>
              <a:cxnSpLocks/>
              <a:stCxn id="11" idx="2"/>
              <a:endCxn id="13" idx="0"/>
            </p:cNvCxnSpPr>
            <p:nvPr/>
          </p:nvCxnSpPr>
          <p:spPr>
            <a:xfrm>
              <a:off x="3496098" y="3641636"/>
              <a:ext cx="0" cy="551267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875296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646D743-D95A-45F4-8E93-DDEC2E2C1D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0623" y="233916"/>
            <a:ext cx="8834804" cy="6213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02985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5FEE2A9-57A5-47AD-B15B-3161B51648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3874" y="828666"/>
            <a:ext cx="9524251" cy="5200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49510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2613A2-5F25-449C-B3B6-B3D66BDB46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6218" y="1031666"/>
            <a:ext cx="7659563" cy="4794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5358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869A3C-B0C4-4F60-A180-FAB7628721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30406" y="217506"/>
            <a:ext cx="2464398" cy="320181"/>
          </a:xfrm>
          <a:ln>
            <a:solidFill>
              <a:schemeClr val="bg1">
                <a:lumMod val="50000"/>
              </a:schemeClr>
            </a:solidFill>
          </a:ln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Faecal sample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DD8805E4-898A-4FC1-9BBE-A3257E66D463}"/>
              </a:ext>
            </a:extLst>
          </p:cNvPr>
          <p:cNvSpPr txBox="1">
            <a:spLocks/>
          </p:cNvSpPr>
          <p:nvPr/>
        </p:nvSpPr>
        <p:spPr>
          <a:xfrm>
            <a:off x="2157609" y="848677"/>
            <a:ext cx="2162540" cy="24506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Microbiome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43297490-414A-47A9-8E6C-1ED4C2C4EBA4}"/>
              </a:ext>
            </a:extLst>
          </p:cNvPr>
          <p:cNvSpPr txBox="1">
            <a:spLocks/>
          </p:cNvSpPr>
          <p:nvPr/>
        </p:nvSpPr>
        <p:spPr>
          <a:xfrm>
            <a:off x="7720921" y="847062"/>
            <a:ext cx="2162540" cy="24506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Metabolome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8DDE2346-6D58-47FD-BC94-629FBCB12E99}"/>
              </a:ext>
            </a:extLst>
          </p:cNvPr>
          <p:cNvSpPr txBox="1">
            <a:spLocks/>
          </p:cNvSpPr>
          <p:nvPr/>
        </p:nvSpPr>
        <p:spPr>
          <a:xfrm>
            <a:off x="2157609" y="1271401"/>
            <a:ext cx="2162539" cy="27418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hotgun sequencing</a:t>
            </a: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105FF587-583B-4D19-9302-3B75AF76CA5A}"/>
              </a:ext>
            </a:extLst>
          </p:cNvPr>
          <p:cNvSpPr txBox="1">
            <a:spLocks/>
          </p:cNvSpPr>
          <p:nvPr/>
        </p:nvSpPr>
        <p:spPr>
          <a:xfrm>
            <a:off x="760880" y="1734139"/>
            <a:ext cx="2393606" cy="29538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Metaxa2 taxonomy assignments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692DE0B6-3B3E-4060-9BCD-603342581FA9}"/>
              </a:ext>
            </a:extLst>
          </p:cNvPr>
          <p:cNvSpPr txBox="1">
            <a:spLocks/>
          </p:cNvSpPr>
          <p:nvPr/>
        </p:nvSpPr>
        <p:spPr>
          <a:xfrm>
            <a:off x="3373216" y="1737532"/>
            <a:ext cx="2370112" cy="29538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KEGG Pathway assignments</a:t>
            </a:r>
          </a:p>
        </p:txBody>
      </p:sp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E6EBADDE-9DC6-4E29-BC83-21FB390B0CB8}"/>
              </a:ext>
            </a:extLst>
          </p:cNvPr>
          <p:cNvSpPr txBox="1">
            <a:spLocks/>
          </p:cNvSpPr>
          <p:nvPr/>
        </p:nvSpPr>
        <p:spPr>
          <a:xfrm>
            <a:off x="7720921" y="1265084"/>
            <a:ext cx="2162540" cy="24506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CMS</a:t>
            </a:r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22B8CBBC-C4DA-4FFC-A320-9089139639B9}"/>
              </a:ext>
            </a:extLst>
          </p:cNvPr>
          <p:cNvSpPr txBox="1">
            <a:spLocks/>
          </p:cNvSpPr>
          <p:nvPr/>
        </p:nvSpPr>
        <p:spPr>
          <a:xfrm>
            <a:off x="6496450" y="1730617"/>
            <a:ext cx="2157804" cy="29538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ipid detection (MS2)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AE852160-1B93-40B2-8012-B458F33571B1}"/>
              </a:ext>
            </a:extLst>
          </p:cNvPr>
          <p:cNvSpPr txBox="1">
            <a:spLocks/>
          </p:cNvSpPr>
          <p:nvPr/>
        </p:nvSpPr>
        <p:spPr>
          <a:xfrm>
            <a:off x="8927901" y="1746605"/>
            <a:ext cx="2162060" cy="28169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Aqueous detection (MS1)</a:t>
            </a: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CCC7EC37-30BC-4C75-8653-3B60C9B6A5C6}"/>
              </a:ext>
            </a:extLst>
          </p:cNvPr>
          <p:cNvSpPr txBox="1">
            <a:spLocks/>
          </p:cNvSpPr>
          <p:nvPr/>
        </p:nvSpPr>
        <p:spPr>
          <a:xfrm>
            <a:off x="2130407" y="2516627"/>
            <a:ext cx="2189742" cy="29538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lpha diversity analysis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5C3C2A84-56EC-4A74-812B-DA605E9458BB}"/>
              </a:ext>
            </a:extLst>
          </p:cNvPr>
          <p:cNvSpPr txBox="1">
            <a:spLocks/>
          </p:cNvSpPr>
          <p:nvPr/>
        </p:nvSpPr>
        <p:spPr>
          <a:xfrm>
            <a:off x="1997335" y="3093378"/>
            <a:ext cx="2464398" cy="29538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Filtering of low abundance reads</a:t>
            </a:r>
          </a:p>
        </p:txBody>
      </p:sp>
      <p:sp>
        <p:nvSpPr>
          <p:cNvPr id="16" name="Content Placeholder 2">
            <a:extLst>
              <a:ext uri="{FF2B5EF4-FFF2-40B4-BE49-F238E27FC236}">
                <a16:creationId xmlns:a16="http://schemas.microsoft.com/office/drawing/2014/main" id="{BF454C92-6EA6-414F-8A67-A5151C58C915}"/>
              </a:ext>
            </a:extLst>
          </p:cNvPr>
          <p:cNvSpPr txBox="1">
            <a:spLocks/>
          </p:cNvSpPr>
          <p:nvPr/>
        </p:nvSpPr>
        <p:spPr>
          <a:xfrm>
            <a:off x="1127038" y="4404657"/>
            <a:ext cx="4196480" cy="1233598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Unsupervised sPCA</a:t>
            </a:r>
          </a:p>
          <a:p>
            <a:pPr marL="0" indent="0"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ervised sPLSDA by timepoint</a:t>
            </a:r>
          </a:p>
          <a:p>
            <a:pPr marL="0" indent="0"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VIP identification of PLSDA components</a:t>
            </a:r>
          </a:p>
          <a:p>
            <a:pPr marL="0" indent="0"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PERMANOVA with FDR correction between timepoints</a:t>
            </a:r>
          </a:p>
        </p:txBody>
      </p:sp>
      <p:sp>
        <p:nvSpPr>
          <p:cNvPr id="18" name="Content Placeholder 2">
            <a:extLst>
              <a:ext uri="{FF2B5EF4-FFF2-40B4-BE49-F238E27FC236}">
                <a16:creationId xmlns:a16="http://schemas.microsoft.com/office/drawing/2014/main" id="{8ED28C17-2662-4020-B64B-776E993F6CC6}"/>
              </a:ext>
            </a:extLst>
          </p:cNvPr>
          <p:cNvSpPr txBox="1">
            <a:spLocks/>
          </p:cNvSpPr>
          <p:nvPr/>
        </p:nvSpPr>
        <p:spPr>
          <a:xfrm>
            <a:off x="7402240" y="2308470"/>
            <a:ext cx="2799902" cy="831938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owess batch normalisation</a:t>
            </a:r>
          </a:p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CV analysis and removal of &gt;30% CV</a:t>
            </a:r>
          </a:p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Annotation</a:t>
            </a:r>
          </a:p>
          <a:p>
            <a:pPr marL="0" indent="0">
              <a:buNone/>
            </a:pPr>
            <a:endParaRPr lang="en-NZ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NZ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ontent Placeholder 2">
            <a:extLst>
              <a:ext uri="{FF2B5EF4-FFF2-40B4-BE49-F238E27FC236}">
                <a16:creationId xmlns:a16="http://schemas.microsoft.com/office/drawing/2014/main" id="{CD9AB019-ACF3-4E14-A6D0-2A3C32C37081}"/>
              </a:ext>
            </a:extLst>
          </p:cNvPr>
          <p:cNvSpPr txBox="1">
            <a:spLocks/>
          </p:cNvSpPr>
          <p:nvPr/>
        </p:nvSpPr>
        <p:spPr>
          <a:xfrm>
            <a:off x="6562794" y="3532427"/>
            <a:ext cx="2157805" cy="81092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Data dependant annotation</a:t>
            </a:r>
          </a:p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ipidBlast</a:t>
            </a:r>
          </a:p>
          <a:p>
            <a:pPr marL="0" indent="0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ipidSearch alignment</a:t>
            </a:r>
          </a:p>
          <a:p>
            <a:pPr marL="0" indent="0">
              <a:buNone/>
            </a:pPr>
            <a:endParaRPr lang="en-NZ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ontent Placeholder 2">
            <a:extLst>
              <a:ext uri="{FF2B5EF4-FFF2-40B4-BE49-F238E27FC236}">
                <a16:creationId xmlns:a16="http://schemas.microsoft.com/office/drawing/2014/main" id="{330C5265-B8D7-488D-87BE-FD95D7C13C0B}"/>
              </a:ext>
            </a:extLst>
          </p:cNvPr>
          <p:cNvSpPr txBox="1">
            <a:spLocks/>
          </p:cNvSpPr>
          <p:nvPr/>
        </p:nvSpPr>
        <p:spPr>
          <a:xfrm>
            <a:off x="7360589" y="5359278"/>
            <a:ext cx="2996227" cy="98996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spcBef>
                <a:spcPts val="0"/>
              </a:spcBef>
              <a:buNone/>
            </a:pP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rrelation of </a:t>
            </a:r>
            <a:r>
              <a:rPr lang="el-G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between timepoints</a:t>
            </a:r>
          </a:p>
          <a:p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etagenome v metabolome</a:t>
            </a:r>
          </a:p>
          <a:p>
            <a:r>
              <a:rPr lang="en-N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axonomy v metabolome </a:t>
            </a:r>
          </a:p>
          <a:p>
            <a:pPr marL="0" indent="0" algn="ctr">
              <a:buNone/>
            </a:pPr>
            <a:endParaRPr lang="en-NZ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ontent Placeholder 2">
            <a:extLst>
              <a:ext uri="{FF2B5EF4-FFF2-40B4-BE49-F238E27FC236}">
                <a16:creationId xmlns:a16="http://schemas.microsoft.com/office/drawing/2014/main" id="{C21A141F-F6C5-48C9-A846-B89AC2CE73E0}"/>
              </a:ext>
            </a:extLst>
          </p:cNvPr>
          <p:cNvSpPr txBox="1">
            <a:spLocks/>
          </p:cNvSpPr>
          <p:nvPr/>
        </p:nvSpPr>
        <p:spPr>
          <a:xfrm>
            <a:off x="8927901" y="3532427"/>
            <a:ext cx="2157805" cy="29876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In house library alignment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4E486A5-87A8-4346-9AFC-7E8D5F672ABA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>
            <a:off x="3238879" y="1093742"/>
            <a:ext cx="0" cy="17765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or: Elbow 24">
            <a:extLst>
              <a:ext uri="{FF2B5EF4-FFF2-40B4-BE49-F238E27FC236}">
                <a16:creationId xmlns:a16="http://schemas.microsoft.com/office/drawing/2014/main" id="{1FDD09A4-DA77-4424-A7E3-05DF1BA4489E}"/>
              </a:ext>
            </a:extLst>
          </p:cNvPr>
          <p:cNvCxnSpPr>
            <a:cxnSpLocks/>
            <a:stCxn id="6" idx="1"/>
            <a:endCxn id="7" idx="0"/>
          </p:cNvCxnSpPr>
          <p:nvPr/>
        </p:nvCxnSpPr>
        <p:spPr>
          <a:xfrm rot="10800000" flipV="1">
            <a:off x="1957683" y="1408491"/>
            <a:ext cx="199926" cy="325648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or: Elbow 26">
            <a:extLst>
              <a:ext uri="{FF2B5EF4-FFF2-40B4-BE49-F238E27FC236}">
                <a16:creationId xmlns:a16="http://schemas.microsoft.com/office/drawing/2014/main" id="{8B77BB83-2CB7-48AA-B924-D9BE388E8A68}"/>
              </a:ext>
            </a:extLst>
          </p:cNvPr>
          <p:cNvCxnSpPr>
            <a:cxnSpLocks/>
            <a:stCxn id="6" idx="3"/>
            <a:endCxn id="8" idx="0"/>
          </p:cNvCxnSpPr>
          <p:nvPr/>
        </p:nvCxnSpPr>
        <p:spPr>
          <a:xfrm>
            <a:off x="4320148" y="1408491"/>
            <a:ext cx="238124" cy="329041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or: Elbow 28">
            <a:extLst>
              <a:ext uri="{FF2B5EF4-FFF2-40B4-BE49-F238E27FC236}">
                <a16:creationId xmlns:a16="http://schemas.microsoft.com/office/drawing/2014/main" id="{36F31C63-6912-4AFB-92F2-CFB07F80EBDC}"/>
              </a:ext>
            </a:extLst>
          </p:cNvPr>
          <p:cNvCxnSpPr>
            <a:cxnSpLocks/>
            <a:stCxn id="8" idx="2"/>
            <a:endCxn id="12" idx="0"/>
          </p:cNvCxnSpPr>
          <p:nvPr/>
        </p:nvCxnSpPr>
        <p:spPr>
          <a:xfrm rot="5400000">
            <a:off x="3649921" y="1608275"/>
            <a:ext cx="483709" cy="1332994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or: Elbow 30">
            <a:extLst>
              <a:ext uri="{FF2B5EF4-FFF2-40B4-BE49-F238E27FC236}">
                <a16:creationId xmlns:a16="http://schemas.microsoft.com/office/drawing/2014/main" id="{4F832D59-E54A-49DE-AC47-E8365AFFBD6B}"/>
              </a:ext>
            </a:extLst>
          </p:cNvPr>
          <p:cNvCxnSpPr>
            <a:cxnSpLocks/>
            <a:stCxn id="7" idx="2"/>
            <a:endCxn id="12" idx="0"/>
          </p:cNvCxnSpPr>
          <p:nvPr/>
        </p:nvCxnSpPr>
        <p:spPr>
          <a:xfrm rot="16200000" flipH="1">
            <a:off x="2347929" y="1639278"/>
            <a:ext cx="487102" cy="1267595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or: Elbow 34">
            <a:extLst>
              <a:ext uri="{FF2B5EF4-FFF2-40B4-BE49-F238E27FC236}">
                <a16:creationId xmlns:a16="http://schemas.microsoft.com/office/drawing/2014/main" id="{A6A0716A-5448-44E2-9770-4A7F7132B723}"/>
              </a:ext>
            </a:extLst>
          </p:cNvPr>
          <p:cNvCxnSpPr>
            <a:cxnSpLocks/>
            <a:endCxn id="13" idx="3"/>
          </p:cNvCxnSpPr>
          <p:nvPr/>
        </p:nvCxnSpPr>
        <p:spPr>
          <a:xfrm rot="5400000">
            <a:off x="4120046" y="2374606"/>
            <a:ext cx="1208153" cy="524777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or: Elbow 36">
            <a:extLst>
              <a:ext uri="{FF2B5EF4-FFF2-40B4-BE49-F238E27FC236}">
                <a16:creationId xmlns:a16="http://schemas.microsoft.com/office/drawing/2014/main" id="{E8110FCB-1DAF-4C69-9853-DE934D30EA1D}"/>
              </a:ext>
            </a:extLst>
          </p:cNvPr>
          <p:cNvCxnSpPr>
            <a:cxnSpLocks/>
            <a:endCxn id="13" idx="1"/>
          </p:cNvCxnSpPr>
          <p:nvPr/>
        </p:nvCxnSpPr>
        <p:spPr>
          <a:xfrm rot="16200000" flipH="1">
            <a:off x="1220305" y="2464041"/>
            <a:ext cx="1211546" cy="342514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or: Elbow 53">
            <a:extLst>
              <a:ext uri="{FF2B5EF4-FFF2-40B4-BE49-F238E27FC236}">
                <a16:creationId xmlns:a16="http://schemas.microsoft.com/office/drawing/2014/main" id="{CDE06EB0-A7B9-4BB0-AFDF-0D1104AC8D1A}"/>
              </a:ext>
            </a:extLst>
          </p:cNvPr>
          <p:cNvCxnSpPr>
            <a:cxnSpLocks/>
            <a:stCxn id="19" idx="2"/>
            <a:endCxn id="111" idx="0"/>
          </p:cNvCxnSpPr>
          <p:nvPr/>
        </p:nvCxnSpPr>
        <p:spPr>
          <a:xfrm rot="16200000" flipH="1">
            <a:off x="8062974" y="3922074"/>
            <a:ext cx="374453" cy="1217007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or: Elbow 55">
            <a:extLst>
              <a:ext uri="{FF2B5EF4-FFF2-40B4-BE49-F238E27FC236}">
                <a16:creationId xmlns:a16="http://schemas.microsoft.com/office/drawing/2014/main" id="{FA78C072-177D-4715-9EAC-4DE6149C9017}"/>
              </a:ext>
            </a:extLst>
          </p:cNvPr>
          <p:cNvCxnSpPr>
            <a:cxnSpLocks/>
            <a:stCxn id="21" idx="2"/>
            <a:endCxn id="111" idx="0"/>
          </p:cNvCxnSpPr>
          <p:nvPr/>
        </p:nvCxnSpPr>
        <p:spPr>
          <a:xfrm rot="5400000">
            <a:off x="8989448" y="3700448"/>
            <a:ext cx="886613" cy="1148100"/>
          </a:xfrm>
          <a:prstGeom prst="bentConnector3">
            <a:avLst>
              <a:gd name="adj1" fmla="val 78334"/>
            </a:avLst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or: Elbow 57">
            <a:extLst>
              <a:ext uri="{FF2B5EF4-FFF2-40B4-BE49-F238E27FC236}">
                <a16:creationId xmlns:a16="http://schemas.microsoft.com/office/drawing/2014/main" id="{F2B92701-42DE-45BF-A628-00A6EC46A812}"/>
              </a:ext>
            </a:extLst>
          </p:cNvPr>
          <p:cNvCxnSpPr>
            <a:cxnSpLocks/>
            <a:stCxn id="10" idx="2"/>
            <a:endCxn id="18" idx="0"/>
          </p:cNvCxnSpPr>
          <p:nvPr/>
        </p:nvCxnSpPr>
        <p:spPr>
          <a:xfrm rot="16200000" flipH="1">
            <a:off x="8047538" y="1553816"/>
            <a:ext cx="282467" cy="1226839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ctor: Elbow 59">
            <a:extLst>
              <a:ext uri="{FF2B5EF4-FFF2-40B4-BE49-F238E27FC236}">
                <a16:creationId xmlns:a16="http://schemas.microsoft.com/office/drawing/2014/main" id="{91032931-4B77-40A6-8DE6-AEF1DBB4A430}"/>
              </a:ext>
            </a:extLst>
          </p:cNvPr>
          <p:cNvCxnSpPr>
            <a:cxnSpLocks/>
            <a:stCxn id="11" idx="2"/>
            <a:endCxn id="18" idx="0"/>
          </p:cNvCxnSpPr>
          <p:nvPr/>
        </p:nvCxnSpPr>
        <p:spPr>
          <a:xfrm rot="5400000">
            <a:off x="9265477" y="1565016"/>
            <a:ext cx="280168" cy="1206740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or: Elbow 63">
            <a:extLst>
              <a:ext uri="{FF2B5EF4-FFF2-40B4-BE49-F238E27FC236}">
                <a16:creationId xmlns:a16="http://schemas.microsoft.com/office/drawing/2014/main" id="{09E98920-39F3-4A7A-BED9-34530DB2D1FE}"/>
              </a:ext>
            </a:extLst>
          </p:cNvPr>
          <p:cNvCxnSpPr>
            <a:cxnSpLocks/>
            <a:stCxn id="18" idx="2"/>
            <a:endCxn id="19" idx="0"/>
          </p:cNvCxnSpPr>
          <p:nvPr/>
        </p:nvCxnSpPr>
        <p:spPr>
          <a:xfrm rot="5400000">
            <a:off x="8025935" y="2756170"/>
            <a:ext cx="392019" cy="1160494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or: Elbow 65">
            <a:extLst>
              <a:ext uri="{FF2B5EF4-FFF2-40B4-BE49-F238E27FC236}">
                <a16:creationId xmlns:a16="http://schemas.microsoft.com/office/drawing/2014/main" id="{BE0649C3-BC19-4921-A48C-BED130549B79}"/>
              </a:ext>
            </a:extLst>
          </p:cNvPr>
          <p:cNvCxnSpPr>
            <a:cxnSpLocks/>
            <a:stCxn id="18" idx="2"/>
            <a:endCxn id="21" idx="0"/>
          </p:cNvCxnSpPr>
          <p:nvPr/>
        </p:nvCxnSpPr>
        <p:spPr>
          <a:xfrm rot="16200000" flipH="1">
            <a:off x="9208488" y="2734110"/>
            <a:ext cx="392019" cy="1204613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CB97E994-4A33-4966-8F4A-F20E1A0F1103}"/>
              </a:ext>
            </a:extLst>
          </p:cNvPr>
          <p:cNvCxnSpPr>
            <a:cxnSpLocks/>
            <a:stCxn id="5" idx="2"/>
            <a:endCxn id="9" idx="0"/>
          </p:cNvCxnSpPr>
          <p:nvPr/>
        </p:nvCxnSpPr>
        <p:spPr>
          <a:xfrm>
            <a:off x="8802191" y="1092127"/>
            <a:ext cx="0" cy="172957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or: Elbow 74">
            <a:extLst>
              <a:ext uri="{FF2B5EF4-FFF2-40B4-BE49-F238E27FC236}">
                <a16:creationId xmlns:a16="http://schemas.microsoft.com/office/drawing/2014/main" id="{FADBB9DD-6472-4FD2-9F6B-7F733B91248D}"/>
              </a:ext>
            </a:extLst>
          </p:cNvPr>
          <p:cNvCxnSpPr>
            <a:cxnSpLocks/>
            <a:stCxn id="9" idx="1"/>
            <a:endCxn id="10" idx="0"/>
          </p:cNvCxnSpPr>
          <p:nvPr/>
        </p:nvCxnSpPr>
        <p:spPr>
          <a:xfrm rot="10800000" flipV="1">
            <a:off x="7575353" y="1387617"/>
            <a:ext cx="145569" cy="343000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or: Elbow 76">
            <a:extLst>
              <a:ext uri="{FF2B5EF4-FFF2-40B4-BE49-F238E27FC236}">
                <a16:creationId xmlns:a16="http://schemas.microsoft.com/office/drawing/2014/main" id="{70409FE4-83C4-4ECC-A58B-202099061BA9}"/>
              </a:ext>
            </a:extLst>
          </p:cNvPr>
          <p:cNvCxnSpPr>
            <a:cxnSpLocks/>
            <a:stCxn id="9" idx="3"/>
            <a:endCxn id="11" idx="0"/>
          </p:cNvCxnSpPr>
          <p:nvPr/>
        </p:nvCxnSpPr>
        <p:spPr>
          <a:xfrm>
            <a:off x="9883461" y="1387617"/>
            <a:ext cx="125470" cy="358988"/>
          </a:xfrm>
          <a:prstGeom prst="bentConnector2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or: Elbow 78">
            <a:extLst>
              <a:ext uri="{FF2B5EF4-FFF2-40B4-BE49-F238E27FC236}">
                <a16:creationId xmlns:a16="http://schemas.microsoft.com/office/drawing/2014/main" id="{3281147F-B172-4C0A-A58B-D64965746329}"/>
              </a:ext>
            </a:extLst>
          </p:cNvPr>
          <p:cNvCxnSpPr>
            <a:cxnSpLocks/>
            <a:stCxn id="3" idx="2"/>
            <a:endCxn id="4" idx="0"/>
          </p:cNvCxnSpPr>
          <p:nvPr/>
        </p:nvCxnSpPr>
        <p:spPr>
          <a:xfrm rot="5400000">
            <a:off x="4495247" y="-718681"/>
            <a:ext cx="310990" cy="2823726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ctor: Elbow 80">
            <a:extLst>
              <a:ext uri="{FF2B5EF4-FFF2-40B4-BE49-F238E27FC236}">
                <a16:creationId xmlns:a16="http://schemas.microsoft.com/office/drawing/2014/main" id="{48801E79-7F88-4B62-ABAD-C3FD6B3E2B9C}"/>
              </a:ext>
            </a:extLst>
          </p:cNvPr>
          <p:cNvCxnSpPr>
            <a:cxnSpLocks/>
            <a:stCxn id="3" idx="2"/>
            <a:endCxn id="5" idx="0"/>
          </p:cNvCxnSpPr>
          <p:nvPr/>
        </p:nvCxnSpPr>
        <p:spPr>
          <a:xfrm rot="16200000" flipH="1">
            <a:off x="7277711" y="-677419"/>
            <a:ext cx="309375" cy="2739586"/>
          </a:xfrm>
          <a:prstGeom prst="bentConnector3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ontent Placeholder 2">
            <a:extLst>
              <a:ext uri="{FF2B5EF4-FFF2-40B4-BE49-F238E27FC236}">
                <a16:creationId xmlns:a16="http://schemas.microsoft.com/office/drawing/2014/main" id="{3B156FD4-E3F5-44A1-9E28-BD87D3631DC6}"/>
              </a:ext>
            </a:extLst>
          </p:cNvPr>
          <p:cNvSpPr txBox="1">
            <a:spLocks/>
          </p:cNvSpPr>
          <p:nvPr/>
        </p:nvSpPr>
        <p:spPr>
          <a:xfrm>
            <a:off x="2051349" y="3791813"/>
            <a:ext cx="2347859" cy="29538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Total sum scaling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24D3143A-5821-40FC-9B8E-63A72A90EC13}"/>
              </a:ext>
            </a:extLst>
          </p:cNvPr>
          <p:cNvCxnSpPr>
            <a:cxnSpLocks/>
            <a:stCxn id="86" idx="2"/>
            <a:endCxn id="16" idx="0"/>
          </p:cNvCxnSpPr>
          <p:nvPr/>
        </p:nvCxnSpPr>
        <p:spPr>
          <a:xfrm flipH="1">
            <a:off x="3225278" y="4087198"/>
            <a:ext cx="1" cy="31745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Content Placeholder 2">
            <a:extLst>
              <a:ext uri="{FF2B5EF4-FFF2-40B4-BE49-F238E27FC236}">
                <a16:creationId xmlns:a16="http://schemas.microsoft.com/office/drawing/2014/main" id="{95F1D058-4810-4A6C-A70B-DEDA949197BB}"/>
              </a:ext>
            </a:extLst>
          </p:cNvPr>
          <p:cNvSpPr txBox="1">
            <a:spLocks/>
          </p:cNvSpPr>
          <p:nvPr/>
        </p:nvSpPr>
        <p:spPr>
          <a:xfrm>
            <a:off x="7779801" y="4717805"/>
            <a:ext cx="2157805" cy="29876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Log ratio transformation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6A2EF46A-2574-43E3-B526-9D61F472B231}"/>
              </a:ext>
            </a:extLst>
          </p:cNvPr>
          <p:cNvCxnSpPr>
            <a:cxnSpLocks/>
            <a:stCxn id="111" idx="2"/>
            <a:endCxn id="20" idx="0"/>
          </p:cNvCxnSpPr>
          <p:nvPr/>
        </p:nvCxnSpPr>
        <p:spPr>
          <a:xfrm flipH="1">
            <a:off x="8858703" y="5016570"/>
            <a:ext cx="1" cy="342708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0E6B2A1F-204F-484A-BAEE-37493E45BB7A}"/>
              </a:ext>
            </a:extLst>
          </p:cNvPr>
          <p:cNvCxnSpPr>
            <a:cxnSpLocks/>
            <a:stCxn id="13" idx="2"/>
            <a:endCxn id="86" idx="0"/>
          </p:cNvCxnSpPr>
          <p:nvPr/>
        </p:nvCxnSpPr>
        <p:spPr>
          <a:xfrm flipH="1">
            <a:off x="3225279" y="3388764"/>
            <a:ext cx="4255" cy="403049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Connector: Elbow 225">
            <a:extLst>
              <a:ext uri="{FF2B5EF4-FFF2-40B4-BE49-F238E27FC236}">
                <a16:creationId xmlns:a16="http://schemas.microsoft.com/office/drawing/2014/main" id="{B1EA6406-BCF3-4A49-8057-10902013D587}"/>
              </a:ext>
            </a:extLst>
          </p:cNvPr>
          <p:cNvCxnSpPr>
            <a:cxnSpLocks/>
            <a:stCxn id="86" idx="3"/>
            <a:endCxn id="20" idx="1"/>
          </p:cNvCxnSpPr>
          <p:nvPr/>
        </p:nvCxnSpPr>
        <p:spPr>
          <a:xfrm>
            <a:off x="4399208" y="3939506"/>
            <a:ext cx="2961381" cy="1914756"/>
          </a:xfrm>
          <a:prstGeom prst="bentConnector3">
            <a:avLst>
              <a:gd name="adj1" fmla="val 50000"/>
            </a:avLst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111396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F99E10DF-7E51-47B8-8D18-FE1C70913B78}"/>
              </a:ext>
            </a:extLst>
          </p:cNvPr>
          <p:cNvGrpSpPr/>
          <p:nvPr/>
        </p:nvGrpSpPr>
        <p:grpSpPr>
          <a:xfrm>
            <a:off x="5742766" y="806073"/>
            <a:ext cx="6202624" cy="4472718"/>
            <a:chOff x="6348161" y="50960"/>
            <a:chExt cx="4486895" cy="385560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7AAD64F-3235-4E0A-9256-9D7B7746DAB5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19" r="65294" b="14150"/>
            <a:stretch/>
          </p:blipFill>
          <p:spPr bwMode="auto">
            <a:xfrm>
              <a:off x="7427929" y="342847"/>
              <a:ext cx="2961433" cy="301364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EFEA2E1-75C8-4A52-AB20-8BD047B235CB}"/>
                </a:ext>
              </a:extLst>
            </p:cNvPr>
            <p:cNvSpPr txBox="1"/>
            <p:nvPr/>
          </p:nvSpPr>
          <p:spPr>
            <a:xfrm>
              <a:off x="6511081" y="351932"/>
              <a:ext cx="8569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EC32F22-8EEE-4231-A089-18AE1C8C0FC6}"/>
                </a:ext>
              </a:extLst>
            </p:cNvPr>
            <p:cNvGrpSpPr/>
            <p:nvPr/>
          </p:nvGrpSpPr>
          <p:grpSpPr>
            <a:xfrm>
              <a:off x="6881040" y="3393581"/>
              <a:ext cx="3954016" cy="512988"/>
              <a:chOff x="6881040" y="3425364"/>
              <a:chExt cx="3954016" cy="512988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5D72DF8-AA12-4EC7-A93E-F34D675D8EB3}"/>
                  </a:ext>
                </a:extLst>
              </p:cNvPr>
              <p:cNvSpPr txBox="1"/>
              <p:nvPr/>
            </p:nvSpPr>
            <p:spPr>
              <a:xfrm>
                <a:off x="6881040" y="3425364"/>
                <a:ext cx="1349926" cy="39796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 months</a:t>
                </a:r>
              </a:p>
              <a:p>
                <a:pPr algn="ctr"/>
                <a:endParaRPr lang="en-NZ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4895D9F-BFD6-43A2-87E4-3DE12F8C63F8}"/>
                  </a:ext>
                </a:extLst>
              </p:cNvPr>
              <p:cNvSpPr txBox="1"/>
              <p:nvPr/>
            </p:nvSpPr>
            <p:spPr>
              <a:xfrm>
                <a:off x="7958106" y="3425506"/>
                <a:ext cx="1949464" cy="39796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 months</a:t>
                </a:r>
              </a:p>
              <a:p>
                <a:pPr algn="ctr"/>
                <a:endParaRPr lang="en-NZ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DD34563-8579-42C7-B560-7DF267C3EE8E}"/>
                  </a:ext>
                </a:extLst>
              </p:cNvPr>
              <p:cNvSpPr txBox="1"/>
              <p:nvPr/>
            </p:nvSpPr>
            <p:spPr>
              <a:xfrm>
                <a:off x="9766194" y="3425364"/>
                <a:ext cx="1068862" cy="23878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 months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60E11B8-5438-4532-B19F-6E3FA22A3C0F}"/>
                  </a:ext>
                </a:extLst>
              </p:cNvPr>
              <p:cNvSpPr txBox="1"/>
              <p:nvPr/>
            </p:nvSpPr>
            <p:spPr>
              <a:xfrm>
                <a:off x="7485404" y="3661353"/>
                <a:ext cx="283845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point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3940DB1-1251-4312-9A61-1C2DF9803F35}"/>
                </a:ext>
              </a:extLst>
            </p:cNvPr>
            <p:cNvSpPr txBox="1"/>
            <p:nvPr/>
          </p:nvSpPr>
          <p:spPr>
            <a:xfrm>
              <a:off x="6511080" y="1189940"/>
              <a:ext cx="8569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658338A-65D1-4C94-9809-DA7EC7FAC9FD}"/>
                </a:ext>
              </a:extLst>
            </p:cNvPr>
            <p:cNvSpPr txBox="1"/>
            <p:nvPr/>
          </p:nvSpPr>
          <p:spPr>
            <a:xfrm>
              <a:off x="6511079" y="2047118"/>
              <a:ext cx="8569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C785457-D064-4E44-9561-C68DECA4825D}"/>
                </a:ext>
              </a:extLst>
            </p:cNvPr>
            <p:cNvSpPr txBox="1"/>
            <p:nvPr/>
          </p:nvSpPr>
          <p:spPr>
            <a:xfrm>
              <a:off x="6511079" y="2893828"/>
              <a:ext cx="8569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90F21FB-217C-4950-8DD1-A54B1FAAD58A}"/>
                </a:ext>
              </a:extLst>
            </p:cNvPr>
            <p:cNvSpPr txBox="1"/>
            <p:nvPr/>
          </p:nvSpPr>
          <p:spPr>
            <a:xfrm rot="16200000">
              <a:off x="5252102" y="1656591"/>
              <a:ext cx="2838450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(%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0BAE385-44CA-4E08-8D86-4D7642CDFECA}"/>
                </a:ext>
              </a:extLst>
            </p:cNvPr>
            <p:cNvSpPr txBox="1"/>
            <p:nvPr/>
          </p:nvSpPr>
          <p:spPr>
            <a:xfrm rot="16200000">
              <a:off x="5341093" y="1169619"/>
              <a:ext cx="2838450" cy="6011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(%)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831019C6-C0A0-4630-88E7-8B15096A634B}"/>
              </a:ext>
            </a:extLst>
          </p:cNvPr>
          <p:cNvGrpSpPr/>
          <p:nvPr/>
        </p:nvGrpSpPr>
        <p:grpSpPr>
          <a:xfrm>
            <a:off x="262806" y="550868"/>
            <a:ext cx="6148326" cy="4733387"/>
            <a:chOff x="584921" y="-115102"/>
            <a:chExt cx="5283231" cy="4022039"/>
          </a:xfrm>
        </p:grpSpPr>
        <p:pic>
          <p:nvPicPr>
            <p:cNvPr id="4" name="Content Placeholder 3">
              <a:extLst>
                <a:ext uri="{FF2B5EF4-FFF2-40B4-BE49-F238E27FC236}">
                  <a16:creationId xmlns:a16="http://schemas.microsoft.com/office/drawing/2014/main" id="{40F26B68-23FA-499A-B9CC-E42F4D070951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71" r="45050"/>
            <a:stretch/>
          </p:blipFill>
          <p:spPr bwMode="auto">
            <a:xfrm>
              <a:off x="1775275" y="398753"/>
              <a:ext cx="3508033" cy="343900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BF272840-2DAE-456D-AB40-9D415A3683D5}"/>
                </a:ext>
              </a:extLst>
            </p:cNvPr>
            <p:cNvGrpSpPr/>
            <p:nvPr/>
          </p:nvGrpSpPr>
          <p:grpSpPr>
            <a:xfrm>
              <a:off x="1266335" y="3405042"/>
              <a:ext cx="4601817" cy="501895"/>
              <a:chOff x="7005768" y="3469397"/>
              <a:chExt cx="3704042" cy="501895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7E2C1FC-7F6F-4E7A-B71D-F683D892A09A}"/>
                  </a:ext>
                </a:extLst>
              </p:cNvPr>
              <p:cNvSpPr txBox="1"/>
              <p:nvPr/>
            </p:nvSpPr>
            <p:spPr>
              <a:xfrm>
                <a:off x="7403470" y="3694293"/>
                <a:ext cx="283845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point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B745E556-75F4-447C-AE04-3C1FD60045AA}"/>
                  </a:ext>
                </a:extLst>
              </p:cNvPr>
              <p:cNvSpPr txBox="1"/>
              <p:nvPr/>
            </p:nvSpPr>
            <p:spPr>
              <a:xfrm>
                <a:off x="7005768" y="3474305"/>
                <a:ext cx="1068862" cy="23537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 month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653923E-4394-45C3-A70B-94C267474EC7}"/>
                  </a:ext>
                </a:extLst>
              </p:cNvPr>
              <p:cNvSpPr txBox="1"/>
              <p:nvPr/>
            </p:nvSpPr>
            <p:spPr>
              <a:xfrm>
                <a:off x="8291837" y="3474305"/>
                <a:ext cx="1068862" cy="23537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 months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B86F66C-FB81-4191-A893-DC5D455C49DE}"/>
                  </a:ext>
                </a:extLst>
              </p:cNvPr>
              <p:cNvSpPr txBox="1"/>
              <p:nvPr/>
            </p:nvSpPr>
            <p:spPr>
              <a:xfrm>
                <a:off x="9640948" y="3469397"/>
                <a:ext cx="1068862" cy="23537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NZ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 months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7CD515A-3611-41A0-BF9B-3A660739BE0C}"/>
                </a:ext>
              </a:extLst>
            </p:cNvPr>
            <p:cNvSpPr txBox="1"/>
            <p:nvPr/>
          </p:nvSpPr>
          <p:spPr>
            <a:xfrm>
              <a:off x="592109" y="560531"/>
              <a:ext cx="11157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98A629B-3FA1-425D-B79D-2EDAC8C4F445}"/>
                </a:ext>
              </a:extLst>
            </p:cNvPr>
            <p:cNvSpPr txBox="1"/>
            <p:nvPr/>
          </p:nvSpPr>
          <p:spPr>
            <a:xfrm>
              <a:off x="584922" y="1328440"/>
              <a:ext cx="11157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40%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8E86FCF-3C57-452D-8043-6EBEA03E627E}"/>
                </a:ext>
              </a:extLst>
            </p:cNvPr>
            <p:cNvSpPr txBox="1"/>
            <p:nvPr/>
          </p:nvSpPr>
          <p:spPr>
            <a:xfrm>
              <a:off x="596630" y="2185618"/>
              <a:ext cx="11157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FB5DAB1-1824-4A16-A51B-149F451BF0EF}"/>
                </a:ext>
              </a:extLst>
            </p:cNvPr>
            <p:cNvSpPr txBox="1"/>
            <p:nvPr/>
          </p:nvSpPr>
          <p:spPr>
            <a:xfrm>
              <a:off x="584921" y="2984079"/>
              <a:ext cx="11157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5BC5C8-9FDA-41F2-B27E-69A4BD012157}"/>
                </a:ext>
              </a:extLst>
            </p:cNvPr>
            <p:cNvSpPr txBox="1"/>
            <p:nvPr/>
          </p:nvSpPr>
          <p:spPr>
            <a:xfrm rot="16200000">
              <a:off x="-430342" y="947087"/>
              <a:ext cx="2838450" cy="7140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abundance (%)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23D46A97-FE70-4A90-BF08-CD26AB4DEFBA}"/>
              </a:ext>
            </a:extLst>
          </p:cNvPr>
          <p:cNvGrpSpPr/>
          <p:nvPr/>
        </p:nvGrpSpPr>
        <p:grpSpPr>
          <a:xfrm>
            <a:off x="2315044" y="5216871"/>
            <a:ext cx="3258612" cy="1114425"/>
            <a:chOff x="2442271" y="4313923"/>
            <a:chExt cx="3258612" cy="1114425"/>
          </a:xfrm>
        </p:grpSpPr>
        <p:pic>
          <p:nvPicPr>
            <p:cNvPr id="7" name="Content Placeholder 3">
              <a:extLst>
                <a:ext uri="{FF2B5EF4-FFF2-40B4-BE49-F238E27FC236}">
                  <a16:creationId xmlns:a16="http://schemas.microsoft.com/office/drawing/2014/main" id="{6CC424CB-92BD-4B45-962B-610D028A3E32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871" t="17242" b="55609"/>
            <a:stretch/>
          </p:blipFill>
          <p:spPr bwMode="auto">
            <a:xfrm>
              <a:off x="2442271" y="4471598"/>
              <a:ext cx="1374254" cy="9336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2" name="Content Placeholder 3">
              <a:extLst>
                <a:ext uri="{FF2B5EF4-FFF2-40B4-BE49-F238E27FC236}">
                  <a16:creationId xmlns:a16="http://schemas.microsoft.com/office/drawing/2014/main" id="{40801323-6894-49D3-9783-9B2A4FDDC071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871" t="44663" b="22931"/>
            <a:stretch/>
          </p:blipFill>
          <p:spPr bwMode="auto">
            <a:xfrm>
              <a:off x="4326629" y="4313923"/>
              <a:ext cx="1374254" cy="1114425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637FEAE2-E13E-4FFA-9E1B-8546A8BEEB40}"/>
              </a:ext>
            </a:extLst>
          </p:cNvPr>
          <p:cNvGrpSpPr/>
          <p:nvPr/>
        </p:nvGrpSpPr>
        <p:grpSpPr>
          <a:xfrm>
            <a:off x="7543294" y="5216871"/>
            <a:ext cx="3849347" cy="1204679"/>
            <a:chOff x="6545238" y="4211761"/>
            <a:chExt cx="3849347" cy="1204679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BD5087AA-7BD7-4E66-8249-265B09C62BF0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779" t="45703" r="19602" b="21106"/>
            <a:stretch/>
          </p:blipFill>
          <p:spPr bwMode="auto">
            <a:xfrm>
              <a:off x="8793124" y="4211761"/>
              <a:ext cx="1601461" cy="120467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6032F5F-AF3E-4D50-9AFE-5D5063E4AF91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780" t="18692" r="6548" b="56186"/>
            <a:stretch/>
          </p:blipFill>
          <p:spPr bwMode="auto">
            <a:xfrm>
              <a:off x="6545238" y="4394638"/>
              <a:ext cx="2172223" cy="911791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F70258F4-CC71-4138-9EE7-81D74C698386}"/>
              </a:ext>
            </a:extLst>
          </p:cNvPr>
          <p:cNvSpPr txBox="1"/>
          <p:nvPr/>
        </p:nvSpPr>
        <p:spPr>
          <a:xfrm>
            <a:off x="1735887" y="774949"/>
            <a:ext cx="3837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equences assigned to phyl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6BCFDDA-6541-4D91-8819-284C39AEC26D}"/>
              </a:ext>
            </a:extLst>
          </p:cNvPr>
          <p:cNvSpPr txBox="1"/>
          <p:nvPr/>
        </p:nvSpPr>
        <p:spPr>
          <a:xfrm>
            <a:off x="7396904" y="774949"/>
            <a:ext cx="3837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equences assigned to level 2 KEGG pathways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9AAE329-941E-47C5-8672-EECAC84F40C8}"/>
              </a:ext>
            </a:extLst>
          </p:cNvPr>
          <p:cNvGrpSpPr/>
          <p:nvPr/>
        </p:nvGrpSpPr>
        <p:grpSpPr>
          <a:xfrm>
            <a:off x="1647552" y="1162349"/>
            <a:ext cx="4114641" cy="3510427"/>
            <a:chOff x="1641752" y="1155217"/>
            <a:chExt cx="4114641" cy="3510427"/>
          </a:xfrm>
        </p:grpSpPr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78F9D96A-B124-487E-A196-832BB232853C}"/>
                </a:ext>
              </a:extLst>
            </p:cNvPr>
            <p:cNvCxnSpPr/>
            <p:nvPr/>
          </p:nvCxnSpPr>
          <p:spPr>
            <a:xfrm flipH="1">
              <a:off x="1641752" y="1155217"/>
              <a:ext cx="0" cy="35104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B7BE66B2-5ACE-43D7-8CEF-591378D465F3}"/>
                </a:ext>
              </a:extLst>
            </p:cNvPr>
            <p:cNvCxnSpPr>
              <a:cxnSpLocks/>
            </p:cNvCxnSpPr>
            <p:nvPr/>
          </p:nvCxnSpPr>
          <p:spPr>
            <a:xfrm>
              <a:off x="1641752" y="4665644"/>
              <a:ext cx="411464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583E1898-FF17-4423-AA9B-EF2D78CEBE8F}"/>
              </a:ext>
            </a:extLst>
          </p:cNvPr>
          <p:cNvGrpSpPr/>
          <p:nvPr/>
        </p:nvGrpSpPr>
        <p:grpSpPr>
          <a:xfrm>
            <a:off x="7230850" y="1105259"/>
            <a:ext cx="4114641" cy="3510427"/>
            <a:chOff x="1641752" y="1155217"/>
            <a:chExt cx="4114641" cy="3510427"/>
          </a:xfrm>
        </p:grpSpPr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91496040-CC6C-45C4-82D9-102AF97174E4}"/>
                </a:ext>
              </a:extLst>
            </p:cNvPr>
            <p:cNvCxnSpPr/>
            <p:nvPr/>
          </p:nvCxnSpPr>
          <p:spPr>
            <a:xfrm flipH="1">
              <a:off x="1641752" y="1155217"/>
              <a:ext cx="0" cy="35104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5B4F50D1-FF8B-42DC-B94D-F3280785580C}"/>
                </a:ext>
              </a:extLst>
            </p:cNvPr>
            <p:cNvCxnSpPr>
              <a:cxnSpLocks/>
            </p:cNvCxnSpPr>
            <p:nvPr/>
          </p:nvCxnSpPr>
          <p:spPr>
            <a:xfrm>
              <a:off x="1641752" y="4665644"/>
              <a:ext cx="411464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9AD7FA15-47D7-4AFB-AAC9-471B24690D41}"/>
              </a:ext>
            </a:extLst>
          </p:cNvPr>
          <p:cNvSpPr txBox="1"/>
          <p:nvPr/>
        </p:nvSpPr>
        <p:spPr>
          <a:xfrm>
            <a:off x="1524883" y="739749"/>
            <a:ext cx="41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D3EA1F3-6149-43F7-AD69-7A688EC4C184}"/>
              </a:ext>
            </a:extLst>
          </p:cNvPr>
          <p:cNvSpPr txBox="1"/>
          <p:nvPr/>
        </p:nvSpPr>
        <p:spPr>
          <a:xfrm>
            <a:off x="7024418" y="739749"/>
            <a:ext cx="41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596070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Content Placeholder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DED3FCB0-552F-4D50-9E87-E799E51DAD0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953"/>
          <a:stretch/>
        </p:blipFill>
        <p:spPr>
          <a:xfrm>
            <a:off x="599270" y="2190749"/>
            <a:ext cx="4909056" cy="4005263"/>
          </a:xfrm>
          <a:prstGeom prst="rect">
            <a:avLst/>
          </a:prstGeom>
        </p:spPr>
      </p:pic>
      <p:pic>
        <p:nvPicPr>
          <p:cNvPr id="5" name="Content Placeholder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34ABD989-3286-4205-B4CB-869AB9474F7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953"/>
          <a:stretch/>
        </p:blipFill>
        <p:spPr>
          <a:xfrm>
            <a:off x="596394" y="2190749"/>
            <a:ext cx="4909056" cy="4005263"/>
          </a:xfrm>
        </p:spPr>
      </p:pic>
      <p:sp>
        <p:nvSpPr>
          <p:cNvPr id="6" name="Right Brace 5">
            <a:extLst>
              <a:ext uri="{FF2B5EF4-FFF2-40B4-BE49-F238E27FC236}">
                <a16:creationId xmlns:a16="http://schemas.microsoft.com/office/drawing/2014/main" id="{B077E9AA-2CE4-4CFD-B75B-87520C8EE446}"/>
              </a:ext>
            </a:extLst>
          </p:cNvPr>
          <p:cNvSpPr/>
          <p:nvPr/>
        </p:nvSpPr>
        <p:spPr>
          <a:xfrm rot="16200000">
            <a:off x="2413763" y="2109087"/>
            <a:ext cx="165098" cy="139217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B3E8572C-72CB-48EC-A8B2-00ECA1F3EFF7}"/>
              </a:ext>
            </a:extLst>
          </p:cNvPr>
          <p:cNvSpPr/>
          <p:nvPr/>
        </p:nvSpPr>
        <p:spPr>
          <a:xfrm rot="16200000">
            <a:off x="3805940" y="1661411"/>
            <a:ext cx="165098" cy="139217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pic>
        <p:nvPicPr>
          <p:cNvPr id="8" name="Content Placeholder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D9A35004-330B-41DC-A468-DBF000EFDBB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23" r="18433" b="90971"/>
          <a:stretch/>
        </p:blipFill>
        <p:spPr>
          <a:xfrm>
            <a:off x="2635951" y="5048250"/>
            <a:ext cx="2778499" cy="50482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8EB881-7700-443E-846B-B65AB80DE846}"/>
              </a:ext>
            </a:extLst>
          </p:cNvPr>
          <p:cNvSpPr txBox="1"/>
          <p:nvPr/>
        </p:nvSpPr>
        <p:spPr>
          <a:xfrm>
            <a:off x="1899288" y="2381372"/>
            <a:ext cx="1293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p = 1.1 e -06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C16863-14B7-4BC2-8FBA-7D49FEFC6578}"/>
              </a:ext>
            </a:extLst>
          </p:cNvPr>
          <p:cNvSpPr txBox="1"/>
          <p:nvPr/>
        </p:nvSpPr>
        <p:spPr>
          <a:xfrm>
            <a:off x="3241933" y="1925072"/>
            <a:ext cx="1293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p = 0.0039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2F4096D-0F2A-4637-86FE-0CF6D18B82A0}"/>
              </a:ext>
            </a:extLst>
          </p:cNvPr>
          <p:cNvSpPr txBox="1"/>
          <p:nvPr/>
        </p:nvSpPr>
        <p:spPr>
          <a:xfrm>
            <a:off x="1048704" y="1456645"/>
            <a:ext cx="42873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equences assigned to species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C3B0F0D-DDF3-4184-A162-3342E772D825}"/>
              </a:ext>
            </a:extLst>
          </p:cNvPr>
          <p:cNvSpPr txBox="1"/>
          <p:nvPr/>
        </p:nvSpPr>
        <p:spPr>
          <a:xfrm>
            <a:off x="7076487" y="1480640"/>
            <a:ext cx="4377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equences assigned to level 4 KEGG pathways</a:t>
            </a:r>
          </a:p>
        </p:txBody>
      </p:sp>
      <p:pic>
        <p:nvPicPr>
          <p:cNvPr id="14" name="Picture 13" descr="Chart, box and whisker chart&#10;&#10;Description automatically generated">
            <a:extLst>
              <a:ext uri="{FF2B5EF4-FFF2-40B4-BE49-F238E27FC236}">
                <a16:creationId xmlns:a16="http://schemas.microsoft.com/office/drawing/2014/main" id="{B1C5E50D-9754-418F-B98A-4492D5B375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58"/>
          <a:stretch/>
        </p:blipFill>
        <p:spPr>
          <a:xfrm>
            <a:off x="6274038" y="2190749"/>
            <a:ext cx="5451126" cy="4019851"/>
          </a:xfrm>
          <a:prstGeom prst="rect">
            <a:avLst/>
          </a:prstGeom>
        </p:spPr>
      </p:pic>
      <p:sp>
        <p:nvSpPr>
          <p:cNvPr id="15" name="Right Brace 14">
            <a:extLst>
              <a:ext uri="{FF2B5EF4-FFF2-40B4-BE49-F238E27FC236}">
                <a16:creationId xmlns:a16="http://schemas.microsoft.com/office/drawing/2014/main" id="{0CEAAFED-D011-4289-9BFD-94426D86A923}"/>
              </a:ext>
            </a:extLst>
          </p:cNvPr>
          <p:cNvSpPr/>
          <p:nvPr/>
        </p:nvSpPr>
        <p:spPr>
          <a:xfrm rot="16200000">
            <a:off x="8283493" y="1523232"/>
            <a:ext cx="207198" cy="146026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6" name="Right Brace 15">
            <a:extLst>
              <a:ext uri="{FF2B5EF4-FFF2-40B4-BE49-F238E27FC236}">
                <a16:creationId xmlns:a16="http://schemas.microsoft.com/office/drawing/2014/main" id="{0482392B-7FF7-415C-A372-3213164AA3C2}"/>
              </a:ext>
            </a:extLst>
          </p:cNvPr>
          <p:cNvSpPr/>
          <p:nvPr/>
        </p:nvSpPr>
        <p:spPr>
          <a:xfrm rot="16200000">
            <a:off x="9895601" y="2216927"/>
            <a:ext cx="155451" cy="156615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D417B47-3970-4207-A862-78873217F9F8}"/>
              </a:ext>
            </a:extLst>
          </p:cNvPr>
          <p:cNvSpPr txBox="1"/>
          <p:nvPr/>
        </p:nvSpPr>
        <p:spPr>
          <a:xfrm>
            <a:off x="7616583" y="1798621"/>
            <a:ext cx="1293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p = 0.630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1249BB-E366-4B96-B880-CACA4CD5BF0C}"/>
              </a:ext>
            </a:extLst>
          </p:cNvPr>
          <p:cNvSpPr txBox="1"/>
          <p:nvPr/>
        </p:nvSpPr>
        <p:spPr>
          <a:xfrm>
            <a:off x="9265204" y="2564375"/>
            <a:ext cx="1293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p = 0.5923</a:t>
            </a:r>
          </a:p>
        </p:txBody>
      </p:sp>
      <p:sp>
        <p:nvSpPr>
          <p:cNvPr id="19" name="Title 1">
            <a:extLst>
              <a:ext uri="{FF2B5EF4-FFF2-40B4-BE49-F238E27FC236}">
                <a16:creationId xmlns:a16="http://schemas.microsoft.com/office/drawing/2014/main" id="{2C470B0A-39E6-49FB-AF65-C4B9CE27F2EB}"/>
              </a:ext>
            </a:extLst>
          </p:cNvPr>
          <p:cNvSpPr txBox="1">
            <a:spLocks/>
          </p:cNvSpPr>
          <p:nvPr/>
        </p:nvSpPr>
        <p:spPr>
          <a:xfrm>
            <a:off x="738079" y="215041"/>
            <a:ext cx="10515600" cy="79962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NZ" sz="2000" b="1" i="1" dirty="0"/>
              <a:t>Figure 2. </a:t>
            </a:r>
            <a:r>
              <a:rPr lang="en-NZ" sz="2000" i="1" dirty="0"/>
              <a:t>Differences in </a:t>
            </a:r>
            <a:r>
              <a:rPr lang="en-NZ" sz="2000" i="1" dirty="0" err="1"/>
              <a:t>shannon</a:t>
            </a:r>
            <a:r>
              <a:rPr lang="en-NZ" sz="2000" i="1" dirty="0"/>
              <a:t> alpha diversity index between sampling timepoints for sequences assigned to level 7 Metaxa2 OTUs (A) and sequences assigned to level 4 KEGG Orthologous pathways. P values provided for T-test comparisons of means between timepoints. Baseline is shown in blue, midpoint in orange, and endpoint in grey.</a:t>
            </a:r>
            <a:endParaRPr lang="en-NZ" sz="2000" dirty="0"/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667BB426-28DF-4EE7-9C26-01B9F95A037C}"/>
              </a:ext>
            </a:extLst>
          </p:cNvPr>
          <p:cNvGrpSpPr/>
          <p:nvPr/>
        </p:nvGrpSpPr>
        <p:grpSpPr>
          <a:xfrm>
            <a:off x="6757639" y="2331244"/>
            <a:ext cx="4899102" cy="3422785"/>
            <a:chOff x="6757639" y="2331244"/>
            <a:chExt cx="4899102" cy="3422785"/>
          </a:xfrm>
        </p:grpSpPr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8E3A6556-CB9B-4AB5-9AE6-58A58C30C323}"/>
                </a:ext>
              </a:extLst>
            </p:cNvPr>
            <p:cNvCxnSpPr>
              <a:cxnSpLocks/>
            </p:cNvCxnSpPr>
            <p:nvPr/>
          </p:nvCxnSpPr>
          <p:spPr>
            <a:xfrm>
              <a:off x="6757639" y="2331244"/>
              <a:ext cx="0" cy="3422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6A7A0491-D076-418C-9541-0839EABAA8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57639" y="5754029"/>
              <a:ext cx="48991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908B5E6E-5F47-401B-9CD5-B53CC0E3FE80}"/>
              </a:ext>
            </a:extLst>
          </p:cNvPr>
          <p:cNvSpPr txBox="1"/>
          <p:nvPr/>
        </p:nvSpPr>
        <p:spPr>
          <a:xfrm>
            <a:off x="811033" y="1438540"/>
            <a:ext cx="405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C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1FCF251-CCD2-48AC-8AE7-B78A26884147}"/>
              </a:ext>
            </a:extLst>
          </p:cNvPr>
          <p:cNvSpPr txBox="1"/>
          <p:nvPr/>
        </p:nvSpPr>
        <p:spPr>
          <a:xfrm>
            <a:off x="6554880" y="1440080"/>
            <a:ext cx="405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D.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020BCC59-5D38-4E06-ACAC-4F7F15EBD1B2}"/>
              </a:ext>
            </a:extLst>
          </p:cNvPr>
          <p:cNvGrpSpPr/>
          <p:nvPr/>
        </p:nvGrpSpPr>
        <p:grpSpPr>
          <a:xfrm>
            <a:off x="936144" y="2331244"/>
            <a:ext cx="4899102" cy="3422785"/>
            <a:chOff x="6757639" y="2331244"/>
            <a:chExt cx="4899102" cy="3422785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D832DEDA-A8A3-4B37-B8F3-9F4B93C3363F}"/>
                </a:ext>
              </a:extLst>
            </p:cNvPr>
            <p:cNvCxnSpPr>
              <a:cxnSpLocks/>
            </p:cNvCxnSpPr>
            <p:nvPr/>
          </p:nvCxnSpPr>
          <p:spPr>
            <a:xfrm>
              <a:off x="6757639" y="2331244"/>
              <a:ext cx="0" cy="3422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2152489-9100-4098-8355-F48310C398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57639" y="5754029"/>
              <a:ext cx="48991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Rectangle 40">
            <a:extLst>
              <a:ext uri="{FF2B5EF4-FFF2-40B4-BE49-F238E27FC236}">
                <a16:creationId xmlns:a16="http://schemas.microsoft.com/office/drawing/2014/main" id="{40D0AF5A-0F5C-4F6E-A609-F529C92BB720}"/>
              </a:ext>
            </a:extLst>
          </p:cNvPr>
          <p:cNvSpPr/>
          <p:nvPr/>
        </p:nvSpPr>
        <p:spPr>
          <a:xfrm>
            <a:off x="11265624" y="5191841"/>
            <a:ext cx="850658" cy="722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A07EA8F6-8A1C-444F-AD35-5573BE4DC7EC}"/>
              </a:ext>
            </a:extLst>
          </p:cNvPr>
          <p:cNvSpPr/>
          <p:nvPr/>
        </p:nvSpPr>
        <p:spPr>
          <a:xfrm>
            <a:off x="5320912" y="5574019"/>
            <a:ext cx="850658" cy="722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3934C9B-A637-4C57-8F85-829151E5005E}"/>
              </a:ext>
            </a:extLst>
          </p:cNvPr>
          <p:cNvGrpSpPr/>
          <p:nvPr/>
        </p:nvGrpSpPr>
        <p:grpSpPr>
          <a:xfrm>
            <a:off x="6791546" y="5788056"/>
            <a:ext cx="4519206" cy="645212"/>
            <a:chOff x="6791546" y="5788056"/>
            <a:chExt cx="4519206" cy="645212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3B715E3-C3B8-4BEA-817D-DCD605E32146}"/>
                </a:ext>
              </a:extLst>
            </p:cNvPr>
            <p:cNvSpPr txBox="1"/>
            <p:nvPr/>
          </p:nvSpPr>
          <p:spPr>
            <a:xfrm>
              <a:off x="6791546" y="5788056"/>
              <a:ext cx="186612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4 months</a:t>
              </a: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9456607-3E5D-449A-AA13-8EC8DB2A3D9A}"/>
                </a:ext>
              </a:extLst>
            </p:cNvPr>
            <p:cNvSpPr txBox="1"/>
            <p:nvPr/>
          </p:nvSpPr>
          <p:spPr>
            <a:xfrm>
              <a:off x="8136069" y="5788056"/>
              <a:ext cx="21083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9 months</a:t>
              </a: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B34D908-3C5F-40E2-910D-6D893C076A01}"/>
                </a:ext>
              </a:extLst>
            </p:cNvPr>
            <p:cNvSpPr txBox="1"/>
            <p:nvPr/>
          </p:nvSpPr>
          <p:spPr>
            <a:xfrm>
              <a:off x="10292712" y="5788056"/>
              <a:ext cx="101804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12 month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096FDCC-D197-47E8-9DE9-37E240AFE5F7}"/>
                </a:ext>
              </a:extLst>
            </p:cNvPr>
            <p:cNvSpPr txBox="1"/>
            <p:nvPr/>
          </p:nvSpPr>
          <p:spPr>
            <a:xfrm>
              <a:off x="7245272" y="6111934"/>
              <a:ext cx="3923835" cy="321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Timepoint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911E129-B94A-4BE3-B079-FE054A1BB4D7}"/>
              </a:ext>
            </a:extLst>
          </p:cNvPr>
          <p:cNvGrpSpPr/>
          <p:nvPr/>
        </p:nvGrpSpPr>
        <p:grpSpPr>
          <a:xfrm>
            <a:off x="771862" y="5823856"/>
            <a:ext cx="4519206" cy="609412"/>
            <a:chOff x="6791546" y="5788056"/>
            <a:chExt cx="4519206" cy="609412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B9CACB8-E527-458B-B381-795576236F62}"/>
                </a:ext>
              </a:extLst>
            </p:cNvPr>
            <p:cNvSpPr txBox="1"/>
            <p:nvPr/>
          </p:nvSpPr>
          <p:spPr>
            <a:xfrm>
              <a:off x="6791546" y="5788056"/>
              <a:ext cx="186612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4 months</a:t>
              </a: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7BEC1E0-B82D-4802-A66B-81B89F281854}"/>
                </a:ext>
              </a:extLst>
            </p:cNvPr>
            <p:cNvSpPr txBox="1"/>
            <p:nvPr/>
          </p:nvSpPr>
          <p:spPr>
            <a:xfrm>
              <a:off x="8136069" y="5788056"/>
              <a:ext cx="21083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9 months</a:t>
              </a:r>
            </a:p>
            <a:p>
              <a:pPr algn="ctr"/>
              <a:endParaRPr lang="en-N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6761F90-DD3B-4DFC-A7FE-C7394FFFF43D}"/>
                </a:ext>
              </a:extLst>
            </p:cNvPr>
            <p:cNvSpPr txBox="1"/>
            <p:nvPr/>
          </p:nvSpPr>
          <p:spPr>
            <a:xfrm>
              <a:off x="10292712" y="5788056"/>
              <a:ext cx="101804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12 month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BD0FFDA-3AE6-410C-9FE9-4E7C7378039B}"/>
                </a:ext>
              </a:extLst>
            </p:cNvPr>
            <p:cNvSpPr txBox="1"/>
            <p:nvPr/>
          </p:nvSpPr>
          <p:spPr>
            <a:xfrm>
              <a:off x="7240611" y="6076134"/>
              <a:ext cx="3923835" cy="32133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NZ" sz="1200" dirty="0">
                  <a:latin typeface="Arial" panose="020B0604020202020204" pitchFamily="34" charset="0"/>
                  <a:cs typeface="Arial" panose="020B0604020202020204" pitchFamily="34" charset="0"/>
                </a:rPr>
                <a:t>Timepoint</a:t>
              </a: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F1F86BBC-42FB-4313-9E65-98F889BB66A2}"/>
              </a:ext>
            </a:extLst>
          </p:cNvPr>
          <p:cNvSpPr txBox="1"/>
          <p:nvPr/>
        </p:nvSpPr>
        <p:spPr>
          <a:xfrm>
            <a:off x="2909439" y="5244787"/>
            <a:ext cx="6562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NZ" sz="900" dirty="0">
                <a:latin typeface="Arial" panose="020B0604020202020204" pitchFamily="34" charset="0"/>
                <a:cs typeface="Arial" panose="020B0604020202020204" pitchFamily="34" charset="0"/>
              </a:rPr>
              <a:t>4 months</a:t>
            </a:r>
          </a:p>
          <a:p>
            <a:pPr algn="ctr"/>
            <a:endParaRPr lang="en-NZ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132A73A-B40B-41FF-B145-6344091BF402}"/>
              </a:ext>
            </a:extLst>
          </p:cNvPr>
          <p:cNvSpPr txBox="1"/>
          <p:nvPr/>
        </p:nvSpPr>
        <p:spPr>
          <a:xfrm>
            <a:off x="3793858" y="5244787"/>
            <a:ext cx="6562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NZ" sz="900" dirty="0">
                <a:latin typeface="Arial" panose="020B0604020202020204" pitchFamily="34" charset="0"/>
                <a:cs typeface="Arial" panose="020B0604020202020204" pitchFamily="34" charset="0"/>
              </a:rPr>
              <a:t>9 months</a:t>
            </a:r>
          </a:p>
          <a:p>
            <a:pPr algn="ctr"/>
            <a:endParaRPr lang="en-NZ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975CBBA-8BDD-4501-A890-E0935DF1559B}"/>
              </a:ext>
            </a:extLst>
          </p:cNvPr>
          <p:cNvSpPr txBox="1"/>
          <p:nvPr/>
        </p:nvSpPr>
        <p:spPr>
          <a:xfrm>
            <a:off x="4673610" y="5240658"/>
            <a:ext cx="7597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NZ" sz="900" dirty="0">
                <a:latin typeface="Arial" panose="020B0604020202020204" pitchFamily="34" charset="0"/>
                <a:cs typeface="Arial" panose="020B0604020202020204" pitchFamily="34" charset="0"/>
              </a:rPr>
              <a:t>12 months</a:t>
            </a:r>
          </a:p>
          <a:p>
            <a:pPr algn="ctr"/>
            <a:endParaRPr lang="en-NZ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19448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8C5870D3-BF0D-4C03-A6E2-62F9158AEB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44" r="9243"/>
          <a:stretch/>
        </p:blipFill>
        <p:spPr>
          <a:xfrm>
            <a:off x="6345383" y="3536687"/>
            <a:ext cx="4935255" cy="3007944"/>
          </a:xfrm>
          <a:prstGeom prst="rect">
            <a:avLst/>
          </a:prstGeom>
        </p:spPr>
      </p:pic>
      <p:pic>
        <p:nvPicPr>
          <p:cNvPr id="11" name="Content Placeholder 10" descr="Chart, diagram&#10;&#10;Description automatically generated">
            <a:extLst>
              <a:ext uri="{FF2B5EF4-FFF2-40B4-BE49-F238E27FC236}">
                <a16:creationId xmlns:a16="http://schemas.microsoft.com/office/drawing/2014/main" id="{654396B4-B5EE-4387-A4A2-CB7800134FA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79" r="9026"/>
          <a:stretch/>
        </p:blipFill>
        <p:spPr>
          <a:xfrm>
            <a:off x="1030262" y="3541191"/>
            <a:ext cx="4978440" cy="3007944"/>
          </a:xfrm>
        </p:spPr>
      </p:pic>
      <p:pic>
        <p:nvPicPr>
          <p:cNvPr id="13" name="Picture 12" descr="Diagram&#10;&#10;Description automatically generated">
            <a:extLst>
              <a:ext uri="{FF2B5EF4-FFF2-40B4-BE49-F238E27FC236}">
                <a16:creationId xmlns:a16="http://schemas.microsoft.com/office/drawing/2014/main" id="{2356BCBC-06AD-454B-A959-883A2F7BB0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44" r="10948"/>
          <a:stretch/>
        </p:blipFill>
        <p:spPr>
          <a:xfrm>
            <a:off x="6367988" y="495664"/>
            <a:ext cx="4842527" cy="2819677"/>
          </a:xfrm>
          <a:prstGeom prst="rect">
            <a:avLst/>
          </a:prstGeom>
        </p:spPr>
      </p:pic>
      <p:pic>
        <p:nvPicPr>
          <p:cNvPr id="15" name="Picture 14" descr="Diagram&#10;&#10;Description automatically generated">
            <a:extLst>
              <a:ext uri="{FF2B5EF4-FFF2-40B4-BE49-F238E27FC236}">
                <a16:creationId xmlns:a16="http://schemas.microsoft.com/office/drawing/2014/main" id="{21E4F4DE-C258-4451-A500-62557A91C6F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43" r="10948" b="1"/>
          <a:stretch/>
        </p:blipFill>
        <p:spPr>
          <a:xfrm>
            <a:off x="1030262" y="501771"/>
            <a:ext cx="4842527" cy="288595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3A86122-A275-4D6A-A188-5B369741D311}"/>
              </a:ext>
            </a:extLst>
          </p:cNvPr>
          <p:cNvSpPr txBox="1"/>
          <p:nvPr/>
        </p:nvSpPr>
        <p:spPr>
          <a:xfrm rot="16200000">
            <a:off x="-770136" y="1657873"/>
            <a:ext cx="2581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Taxonomic assignment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C8038F1-9F6A-435C-BD85-F8FC1272397E}"/>
              </a:ext>
            </a:extLst>
          </p:cNvPr>
          <p:cNvSpPr txBox="1"/>
          <p:nvPr/>
        </p:nvSpPr>
        <p:spPr>
          <a:xfrm rot="16200000">
            <a:off x="-1542555" y="4753658"/>
            <a:ext cx="4057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KEGG pathway assignment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8463AF-755E-467E-9453-CAACF659A0FB}"/>
              </a:ext>
            </a:extLst>
          </p:cNvPr>
          <p:cNvSpPr txBox="1"/>
          <p:nvPr/>
        </p:nvSpPr>
        <p:spPr>
          <a:xfrm>
            <a:off x="2039860" y="214910"/>
            <a:ext cx="2922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Unsupervised sPC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076CA00-3336-4915-8169-6DEAE2F2B76C}"/>
              </a:ext>
            </a:extLst>
          </p:cNvPr>
          <p:cNvSpPr txBox="1"/>
          <p:nvPr/>
        </p:nvSpPr>
        <p:spPr>
          <a:xfrm>
            <a:off x="7741688" y="212730"/>
            <a:ext cx="25818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>
                <a:latin typeface="Arial" panose="020B0604020202020204" pitchFamily="34" charset="0"/>
                <a:cs typeface="Arial" panose="020B0604020202020204" pitchFamily="34" charset="0"/>
              </a:rPr>
              <a:t>Supervised sPLSDA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119FE6E-362D-4349-A108-5F954A3078B0}"/>
              </a:ext>
            </a:extLst>
          </p:cNvPr>
          <p:cNvGrpSpPr/>
          <p:nvPr/>
        </p:nvGrpSpPr>
        <p:grpSpPr>
          <a:xfrm>
            <a:off x="1543574" y="2419119"/>
            <a:ext cx="992572" cy="553998"/>
            <a:chOff x="5339186" y="3191351"/>
            <a:chExt cx="915674" cy="553998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E5141AF-8627-43C3-B1C4-DB53D6FD8184}"/>
                </a:ext>
              </a:extLst>
            </p:cNvPr>
            <p:cNvSpPr txBox="1"/>
            <p:nvPr/>
          </p:nvSpPr>
          <p:spPr>
            <a:xfrm>
              <a:off x="5339186" y="3191351"/>
              <a:ext cx="915674" cy="553998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NZ" sz="1000" dirty="0">
                  <a:latin typeface="Arial" panose="020B0604020202020204" pitchFamily="34" charset="0"/>
                  <a:cs typeface="Arial" panose="020B0604020202020204" pitchFamily="34" charset="0"/>
                </a:rPr>
                <a:t>4 months</a:t>
              </a:r>
            </a:p>
            <a:p>
              <a:pPr algn="r"/>
              <a:r>
                <a:rPr lang="en-NZ" sz="1000" dirty="0">
                  <a:latin typeface="Arial" panose="020B0604020202020204" pitchFamily="34" charset="0"/>
                  <a:cs typeface="Arial" panose="020B0604020202020204" pitchFamily="34" charset="0"/>
                </a:rPr>
                <a:t>9 months</a:t>
              </a:r>
            </a:p>
            <a:p>
              <a:pPr algn="r"/>
              <a:r>
                <a:rPr lang="en-NZ" sz="1000" dirty="0">
                  <a:latin typeface="Arial" panose="020B0604020202020204" pitchFamily="34" charset="0"/>
                  <a:cs typeface="Arial" panose="020B0604020202020204" pitchFamily="34" charset="0"/>
                </a:rPr>
                <a:t>12 months</a:t>
              </a:r>
            </a:p>
          </p:txBody>
        </p:sp>
        <p:pic>
          <p:nvPicPr>
            <p:cNvPr id="28" name="Picture 27" descr="Chart, scatter chart&#10;&#10;Description automatically generated">
              <a:extLst>
                <a:ext uri="{FF2B5EF4-FFF2-40B4-BE49-F238E27FC236}">
                  <a16:creationId xmlns:a16="http://schemas.microsoft.com/office/drawing/2014/main" id="{1F75956F-C406-47FB-94DB-37FFF37B8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41" t="45661" r="5227" b="40790"/>
            <a:stretch/>
          </p:blipFill>
          <p:spPr>
            <a:xfrm>
              <a:off x="5393360" y="3223443"/>
              <a:ext cx="235458" cy="482533"/>
            </a:xfrm>
            <a:prstGeom prst="rect">
              <a:avLst/>
            </a:prstGeom>
          </p:spPr>
        </p:pic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BAC762BB-2B62-4410-9884-C7E87CE5847C}"/>
              </a:ext>
            </a:extLst>
          </p:cNvPr>
          <p:cNvSpPr txBox="1"/>
          <p:nvPr/>
        </p:nvSpPr>
        <p:spPr>
          <a:xfrm>
            <a:off x="675504" y="160044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A6246DE-2F36-4132-8402-50574AE828F9}"/>
              </a:ext>
            </a:extLst>
          </p:cNvPr>
          <p:cNvSpPr txBox="1"/>
          <p:nvPr/>
        </p:nvSpPr>
        <p:spPr>
          <a:xfrm>
            <a:off x="6123531" y="160044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FEDEBC4-0703-4335-8CAA-17D8F70EB802}"/>
              </a:ext>
            </a:extLst>
          </p:cNvPr>
          <p:cNvSpPr txBox="1"/>
          <p:nvPr/>
        </p:nvSpPr>
        <p:spPr>
          <a:xfrm>
            <a:off x="690925" y="3415573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7BDB1E8-563E-4430-B1AC-68CBF3769FE8}"/>
              </a:ext>
            </a:extLst>
          </p:cNvPr>
          <p:cNvSpPr txBox="1"/>
          <p:nvPr/>
        </p:nvSpPr>
        <p:spPr>
          <a:xfrm>
            <a:off x="6100926" y="3409811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9979BC1-71B8-48F7-919C-BC7704D27D28}"/>
              </a:ext>
            </a:extLst>
          </p:cNvPr>
          <p:cNvSpPr txBox="1"/>
          <p:nvPr/>
        </p:nvSpPr>
        <p:spPr>
          <a:xfrm>
            <a:off x="1970546" y="6381480"/>
            <a:ext cx="29224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1 (63%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8C95CB0-FF43-47F7-8609-C3807EAD37EB}"/>
              </a:ext>
            </a:extLst>
          </p:cNvPr>
          <p:cNvSpPr txBox="1"/>
          <p:nvPr/>
        </p:nvSpPr>
        <p:spPr>
          <a:xfrm rot="16200000">
            <a:off x="-203672" y="4889288"/>
            <a:ext cx="24678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2 (17%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35C97EE-4E7D-4537-92F4-9738ABEA9DBA}"/>
              </a:ext>
            </a:extLst>
          </p:cNvPr>
          <p:cNvSpPr txBox="1"/>
          <p:nvPr/>
        </p:nvSpPr>
        <p:spPr>
          <a:xfrm>
            <a:off x="8114892" y="6335482"/>
            <a:ext cx="1348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1 (31%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4328772-3B72-4989-8E4E-06C3CAFBB92B}"/>
              </a:ext>
            </a:extLst>
          </p:cNvPr>
          <p:cNvSpPr txBox="1"/>
          <p:nvPr/>
        </p:nvSpPr>
        <p:spPr>
          <a:xfrm rot="16200000">
            <a:off x="5679838" y="4856254"/>
            <a:ext cx="1348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2 (31%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7D04C30-CD98-436D-B0D5-8CA8B31445B8}"/>
              </a:ext>
            </a:extLst>
          </p:cNvPr>
          <p:cNvSpPr txBox="1"/>
          <p:nvPr/>
        </p:nvSpPr>
        <p:spPr>
          <a:xfrm>
            <a:off x="7469706" y="3148201"/>
            <a:ext cx="29224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1 (11%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F61E905-0B19-4A79-B07A-5D50F5DBFFAF}"/>
              </a:ext>
            </a:extLst>
          </p:cNvPr>
          <p:cNvSpPr txBox="1"/>
          <p:nvPr/>
        </p:nvSpPr>
        <p:spPr>
          <a:xfrm rot="16200000">
            <a:off x="5719328" y="1680956"/>
            <a:ext cx="1348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2 (7%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515C921-D0A8-46E6-8BAF-9B85294653AF}"/>
              </a:ext>
            </a:extLst>
          </p:cNvPr>
          <p:cNvSpPr txBox="1"/>
          <p:nvPr/>
        </p:nvSpPr>
        <p:spPr>
          <a:xfrm>
            <a:off x="2100486" y="3216772"/>
            <a:ext cx="29224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1 (12%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695FBD3-55A5-46F3-BB87-351999B5D070}"/>
              </a:ext>
            </a:extLst>
          </p:cNvPr>
          <p:cNvSpPr txBox="1"/>
          <p:nvPr/>
        </p:nvSpPr>
        <p:spPr>
          <a:xfrm rot="16200000">
            <a:off x="-137968" y="1852033"/>
            <a:ext cx="246786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2 (7%)</a:t>
            </a:r>
          </a:p>
        </p:txBody>
      </p:sp>
    </p:spTree>
    <p:extLst>
      <p:ext uri="{BB962C8B-B14F-4D97-AF65-F5344CB8AC3E}">
        <p14:creationId xmlns:p14="http://schemas.microsoft.com/office/powerpoint/2010/main" val="26050798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4E414C4A-5455-47A4-BE61-5EBA62A1BE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93" r="9604"/>
          <a:stretch/>
        </p:blipFill>
        <p:spPr>
          <a:xfrm>
            <a:off x="1076720" y="520844"/>
            <a:ext cx="4958544" cy="2915227"/>
          </a:xfrm>
          <a:prstGeom prst="rect">
            <a:avLst/>
          </a:prstGeom>
        </p:spPr>
      </p:pic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08076078-17DD-4159-84BA-BEB13B9F36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87" r="11784"/>
          <a:stretch/>
        </p:blipFill>
        <p:spPr>
          <a:xfrm>
            <a:off x="6376738" y="513773"/>
            <a:ext cx="4856038" cy="2915227"/>
          </a:xfrm>
          <a:prstGeom prst="rect">
            <a:avLst/>
          </a:prstGeom>
        </p:spPr>
      </p:pic>
      <p:pic>
        <p:nvPicPr>
          <p:cNvPr id="9" name="Picture 8" descr="Diagram, engineering drawing&#10;&#10;Description automatically generated">
            <a:extLst>
              <a:ext uri="{FF2B5EF4-FFF2-40B4-BE49-F238E27FC236}">
                <a16:creationId xmlns:a16="http://schemas.microsoft.com/office/drawing/2014/main" id="{29146C7E-CC92-424D-A1DF-8FE4FBA2989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50" r="6279"/>
          <a:stretch/>
        </p:blipFill>
        <p:spPr>
          <a:xfrm>
            <a:off x="1167101" y="3670479"/>
            <a:ext cx="4868163" cy="2915228"/>
          </a:xfrm>
          <a:prstGeom prst="rect">
            <a:avLst/>
          </a:prstGeom>
        </p:spPr>
      </p:pic>
      <p:pic>
        <p:nvPicPr>
          <p:cNvPr id="11" name="Picture 10" descr="Diagram&#10;&#10;Description automatically generated">
            <a:extLst>
              <a:ext uri="{FF2B5EF4-FFF2-40B4-BE49-F238E27FC236}">
                <a16:creationId xmlns:a16="http://schemas.microsoft.com/office/drawing/2014/main" id="{6434E486-B3FA-4187-97AC-E49CE89EC1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49" r="7248" b="1"/>
          <a:stretch/>
        </p:blipFill>
        <p:spPr>
          <a:xfrm>
            <a:off x="6472990" y="3670479"/>
            <a:ext cx="4796364" cy="291522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EEA844C-465D-4633-B214-DA601A77763A}"/>
              </a:ext>
            </a:extLst>
          </p:cNvPr>
          <p:cNvSpPr txBox="1"/>
          <p:nvPr/>
        </p:nvSpPr>
        <p:spPr>
          <a:xfrm rot="16200000">
            <a:off x="-614864" y="1657873"/>
            <a:ext cx="2581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Aqueous metabolit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5655010-2843-46AD-B2BC-9B101DFFE792}"/>
              </a:ext>
            </a:extLst>
          </p:cNvPr>
          <p:cNvSpPr txBox="1"/>
          <p:nvPr/>
        </p:nvSpPr>
        <p:spPr>
          <a:xfrm rot="16200000">
            <a:off x="-614865" y="4807508"/>
            <a:ext cx="2581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Lipid metabolite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24C0D36-D365-4285-8083-9367FED7D0A6}"/>
              </a:ext>
            </a:extLst>
          </p:cNvPr>
          <p:cNvSpPr txBox="1"/>
          <p:nvPr/>
        </p:nvSpPr>
        <p:spPr>
          <a:xfrm>
            <a:off x="678189" y="278064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D62E011-456E-4AC5-B381-0A11ABD9E55E}"/>
              </a:ext>
            </a:extLst>
          </p:cNvPr>
          <p:cNvSpPr txBox="1"/>
          <p:nvPr/>
        </p:nvSpPr>
        <p:spPr>
          <a:xfrm>
            <a:off x="678187" y="3436071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F9ACEA2-F2BB-47C8-8CB5-1EAF60DFE710}"/>
              </a:ext>
            </a:extLst>
          </p:cNvPr>
          <p:cNvSpPr txBox="1"/>
          <p:nvPr/>
        </p:nvSpPr>
        <p:spPr>
          <a:xfrm>
            <a:off x="6155064" y="272295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4035AE-629E-4793-9FAD-F12BEC25FB6C}"/>
              </a:ext>
            </a:extLst>
          </p:cNvPr>
          <p:cNvSpPr txBox="1"/>
          <p:nvPr/>
        </p:nvSpPr>
        <p:spPr>
          <a:xfrm>
            <a:off x="6156736" y="3429000"/>
            <a:ext cx="488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400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0E3A6AA-FDDB-451B-814A-5D1758172396}"/>
              </a:ext>
            </a:extLst>
          </p:cNvPr>
          <p:cNvSpPr txBox="1"/>
          <p:nvPr/>
        </p:nvSpPr>
        <p:spPr>
          <a:xfrm>
            <a:off x="2942828" y="3167390"/>
            <a:ext cx="122632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1 (34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B992DFD-BEC2-462D-A8E3-B1B34D16B04C}"/>
              </a:ext>
            </a:extLst>
          </p:cNvPr>
          <p:cNvSpPr txBox="1"/>
          <p:nvPr/>
        </p:nvSpPr>
        <p:spPr>
          <a:xfrm rot="16200000">
            <a:off x="288613" y="1743397"/>
            <a:ext cx="16028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2 (47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443B91-609C-42F7-B9B3-682E46A90ECC}"/>
              </a:ext>
            </a:extLst>
          </p:cNvPr>
          <p:cNvSpPr txBox="1"/>
          <p:nvPr/>
        </p:nvSpPr>
        <p:spPr>
          <a:xfrm>
            <a:off x="2942828" y="6341957"/>
            <a:ext cx="122632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1 (19%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44CC59A-25E1-4B5D-9F6C-696292905B6E}"/>
              </a:ext>
            </a:extLst>
          </p:cNvPr>
          <p:cNvSpPr txBox="1"/>
          <p:nvPr/>
        </p:nvSpPr>
        <p:spPr>
          <a:xfrm rot="16200000">
            <a:off x="402227" y="4830590"/>
            <a:ext cx="122632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PC2 (14%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A51EAEB-45A9-4625-B553-0E4A58BEA73B}"/>
              </a:ext>
            </a:extLst>
          </p:cNvPr>
          <p:cNvSpPr txBox="1"/>
          <p:nvPr/>
        </p:nvSpPr>
        <p:spPr>
          <a:xfrm>
            <a:off x="8389223" y="3167390"/>
            <a:ext cx="15391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1 (13%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6727CE-A248-4D06-A2DC-093AB48F9D54}"/>
              </a:ext>
            </a:extLst>
          </p:cNvPr>
          <p:cNvSpPr txBox="1"/>
          <p:nvPr/>
        </p:nvSpPr>
        <p:spPr>
          <a:xfrm rot="16200000">
            <a:off x="5885387" y="1815750"/>
            <a:ext cx="12275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2 (7%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CA9DF1A-67E3-47FC-AD79-F8BC910CC9AE}"/>
              </a:ext>
            </a:extLst>
          </p:cNvPr>
          <p:cNvSpPr txBox="1"/>
          <p:nvPr/>
        </p:nvSpPr>
        <p:spPr>
          <a:xfrm>
            <a:off x="8478261" y="6341957"/>
            <a:ext cx="122632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 -variate1 (9%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7F622FD-55E1-46CD-B682-B62A419D4FA2}"/>
              </a:ext>
            </a:extLst>
          </p:cNvPr>
          <p:cNvSpPr txBox="1"/>
          <p:nvPr/>
        </p:nvSpPr>
        <p:spPr>
          <a:xfrm rot="16200000">
            <a:off x="5729032" y="4798721"/>
            <a:ext cx="147838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X-variate 2 (15%)</a:t>
            </a:r>
          </a:p>
        </p:txBody>
      </p:sp>
    </p:spTree>
    <p:extLst>
      <p:ext uri="{BB962C8B-B14F-4D97-AF65-F5344CB8AC3E}">
        <p14:creationId xmlns:p14="http://schemas.microsoft.com/office/powerpoint/2010/main" val="26057057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F1A67E2-74EB-48F6-970F-56CA59B23A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3493" y="822466"/>
            <a:ext cx="5365013" cy="5213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05604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DFFC036-95D9-4D58-9B6F-A26FB973B5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8012" y="301647"/>
            <a:ext cx="6731610" cy="61070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15723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1761E93-7F0D-45A7-B3C8-E06E8E1995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7193" y="281763"/>
            <a:ext cx="7823028" cy="6294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2373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?mso-contentType ?>
<SharedContentType xmlns="Microsoft.SharePoint.Taxonomy.ContentTypeSync" SourceId="12bbd033-7c10-4bc6-94c7-41b14f0b8859" ContentTypeId="0x0101" PreviousValue="false"/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FEA30E680F544F806976D20625BB3C" ma:contentTypeVersion="15" ma:contentTypeDescription="Create a new document." ma:contentTypeScope="" ma:versionID="3a13b880f94dee84a295415eac53d42f">
  <xsd:schema xmlns:xsd="http://www.w3.org/2001/XMLSchema" xmlns:xs="http://www.w3.org/2001/XMLSchema" xmlns:p="http://schemas.microsoft.com/office/2006/metadata/properties" xmlns:ns3="7eac3473-afb6-4782-ba55-074fa82562bd" xmlns:ns4="dfbd20a2-319e-4aeb-98a6-53a5586a0db7" xmlns:ns5="c6d937d3-d012-4ba4-9fe3-87378e41c7f0" targetNamespace="http://schemas.microsoft.com/office/2006/metadata/properties" ma:root="true" ma:fieldsID="d0818e9ea8bd0896bb01b9eb6a13706e" ns3:_="" ns4:_="" ns5:_="">
    <xsd:import namespace="7eac3473-afb6-4782-ba55-074fa82562bd"/>
    <xsd:import namespace="dfbd20a2-319e-4aeb-98a6-53a5586a0db7"/>
    <xsd:import namespace="c6d937d3-d012-4ba4-9fe3-87378e41c7f0"/>
    <xsd:element name="properties">
      <xsd:complexType>
        <xsd:sequence>
          <xsd:element name="documentManagement">
            <xsd:complexType>
              <xsd:all>
                <xsd:element ref="ns3:TaxCatchAll" minOccurs="0"/>
                <xsd:element ref="ns3:TaxCatchAllLabel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5:SharedWithUsers" minOccurs="0"/>
                <xsd:element ref="ns5:SharedWithDetails" minOccurs="0"/>
                <xsd:element ref="ns5:SharingHintHash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ac3473-afb6-4782-ba55-074fa82562bd" elementFormDefault="qualified">
    <xsd:import namespace="http://schemas.microsoft.com/office/2006/documentManagement/types"/>
    <xsd:import namespace="http://schemas.microsoft.com/office/infopath/2007/PartnerControls"/>
    <xsd:element name="TaxCatchAll" ma:index="4" nillable="true" ma:displayName="Taxonomy Catch All Column" ma:hidden="true" ma:list="{2f52280e-97c4-40fb-b08f-28aba42c3df8}" ma:internalName="TaxCatchAll" ma:showField="CatchAllData" ma:web="c6d937d3-d012-4ba4-9fe3-87378e41c7f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5" nillable="true" ma:displayName="Taxonomy Catch All Column1" ma:hidden="true" ma:list="{2f52280e-97c4-40fb-b08f-28aba42c3df8}" ma:internalName="TaxCatchAllLabel" ma:readOnly="true" ma:showField="CatchAllDataLabel" ma:web="c6d937d3-d012-4ba4-9fe3-87378e41c7f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fbd20a2-319e-4aeb-98a6-53a5586a0db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d937d3-d012-4ba4-9fe3-87378e41c7f0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7" ma:displayName="Content Type"/>
        <xsd:element ref="dc:title" minOccurs="0" maxOccurs="1" ma:index="1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eac3473-afb6-4782-ba55-074fa82562bd"/>
  </documentManagement>
</p:properties>
</file>

<file path=customXml/itemProps1.xml><?xml version="1.0" encoding="utf-8"?>
<ds:datastoreItem xmlns:ds="http://schemas.openxmlformats.org/officeDocument/2006/customXml" ds:itemID="{81BC0EF5-1DD5-4022-B55A-5BD0C321D54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1EDAEE7-B158-4D11-BBBD-B5EEA727BD2C}">
  <ds:schemaRefs>
    <ds:schemaRef ds:uri="Microsoft.SharePoint.Taxonomy.ContentTypeSync"/>
  </ds:schemaRefs>
</ds:datastoreItem>
</file>

<file path=customXml/itemProps3.xml><?xml version="1.0" encoding="utf-8"?>
<ds:datastoreItem xmlns:ds="http://schemas.openxmlformats.org/officeDocument/2006/customXml" ds:itemID="{43523165-5AB6-402C-B04C-67F3E2E8AA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eac3473-afb6-4782-ba55-074fa82562bd"/>
    <ds:schemaRef ds:uri="dfbd20a2-319e-4aeb-98a6-53a5586a0db7"/>
    <ds:schemaRef ds:uri="c6d937d3-d012-4ba4-9fe3-87378e41c7f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4.xml><?xml version="1.0" encoding="utf-8"?>
<ds:datastoreItem xmlns:ds="http://schemas.openxmlformats.org/officeDocument/2006/customXml" ds:itemID="{21901C37-FFC3-4660-88D0-ECF06F0E1B1D}">
  <ds:schemaRefs>
    <ds:schemaRef ds:uri="http://schemas.microsoft.com/office/2006/metadata/properties"/>
    <ds:schemaRef ds:uri="http://schemas.microsoft.com/office/infopath/2007/PartnerControls"/>
    <ds:schemaRef ds:uri="7eac3473-afb6-4782-ba55-074fa82562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488</Words>
  <Application>Microsoft Office PowerPoint</Application>
  <PresentationFormat>Widescreen</PresentationFormat>
  <Paragraphs>137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rin McKeen</dc:creator>
  <cp:lastModifiedBy>Starin McKeen</cp:lastModifiedBy>
  <cp:revision>3</cp:revision>
  <dcterms:created xsi:type="dcterms:W3CDTF">2020-11-10T20:43:14Z</dcterms:created>
  <dcterms:modified xsi:type="dcterms:W3CDTF">2021-03-19T01:2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FEA30E680F544F806976D20625BB3C</vt:lpwstr>
  </property>
</Properties>
</file>